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jpg" ContentType="image/jpeg"/>
  <Default Extension="mp4" ContentType="video/mp4"/>
  <Default Extension="tiff" ContentType="image/tiff"/>
  <Default Extension="rels" ContentType="application/vnd.openxmlformats-package.relationships+xml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sldIdLst>
    <p:sldId id="267" r:id="rId2"/>
    <p:sldId id="259" r:id="rId3"/>
    <p:sldId id="269" r:id="rId4"/>
    <p:sldId id="275" r:id="rId5"/>
    <p:sldId id="265" r:id="rId6"/>
    <p:sldId id="276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CC84C"/>
    <a:srgbClr val="EDBCA8"/>
    <a:srgbClr val="CDE3CD"/>
    <a:srgbClr val="CEE4CE"/>
    <a:srgbClr val="EDBBA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5068"/>
    <p:restoredTop sz="94546"/>
  </p:normalViewPr>
  <p:slideViewPr>
    <p:cSldViewPr snapToGrid="0" snapToObjects="1">
      <p:cViewPr varScale="1">
        <p:scale>
          <a:sx n="138" d="100"/>
          <a:sy n="138" d="100"/>
        </p:scale>
        <p:origin x="208" y="9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theme" Target="theme/theme1.xml"/><Relationship Id="rId12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notesMaster" Target="notesMasters/notesMaster1.xml"/><Relationship Id="rId9" Type="http://schemas.openxmlformats.org/officeDocument/2006/relationships/presProps" Target="presProps.xml"/><Relationship Id="rId10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localhost//Users/andrey/Dropbox/World_Clay/ClayWaterFract.xlsx" TargetMode="External"/><Relationship Id="rId2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9223377148459"/>
          <c:y val="0.0457679479104756"/>
          <c:w val="0.741749213916514"/>
          <c:h val="0.802786993586389"/>
        </c:manualLayout>
      </c:layout>
      <c:scatterChart>
        <c:scatterStyle val="smoothMarker"/>
        <c:varyColors val="0"/>
        <c:ser>
          <c:idx val="0"/>
          <c:order val="0"/>
          <c:tx>
            <c:v>Smectite</c:v>
          </c:tx>
          <c:marker>
            <c:symbol val="none"/>
          </c:marker>
          <c:xVal>
            <c:numRef>
              <c:f>'Fract factors'!$A$4:$A$29</c:f>
              <c:numCache>
                <c:formatCode>General</c:formatCode>
                <c:ptCount val="26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0</c:v>
                </c:pt>
                <c:pt idx="4">
                  <c:v>8.0</c:v>
                </c:pt>
                <c:pt idx="5">
                  <c:v>10.0</c:v>
                </c:pt>
                <c:pt idx="6">
                  <c:v>12.0</c:v>
                </c:pt>
                <c:pt idx="7">
                  <c:v>14.0</c:v>
                </c:pt>
                <c:pt idx="8">
                  <c:v>16.0</c:v>
                </c:pt>
                <c:pt idx="9">
                  <c:v>18.0</c:v>
                </c:pt>
                <c:pt idx="10">
                  <c:v>20.0</c:v>
                </c:pt>
                <c:pt idx="11">
                  <c:v>22.0</c:v>
                </c:pt>
                <c:pt idx="12">
                  <c:v>24.0</c:v>
                </c:pt>
                <c:pt idx="13">
                  <c:v>26.0</c:v>
                </c:pt>
                <c:pt idx="14">
                  <c:v>28.0</c:v>
                </c:pt>
                <c:pt idx="15">
                  <c:v>30.0</c:v>
                </c:pt>
                <c:pt idx="16">
                  <c:v>32.0</c:v>
                </c:pt>
                <c:pt idx="17">
                  <c:v>34.0</c:v>
                </c:pt>
                <c:pt idx="18">
                  <c:v>36.0</c:v>
                </c:pt>
                <c:pt idx="19">
                  <c:v>38.0</c:v>
                </c:pt>
                <c:pt idx="20">
                  <c:v>40.0</c:v>
                </c:pt>
                <c:pt idx="21">
                  <c:v>42.0</c:v>
                </c:pt>
                <c:pt idx="22">
                  <c:v>44.0</c:v>
                </c:pt>
                <c:pt idx="23">
                  <c:v>46.0</c:v>
                </c:pt>
                <c:pt idx="24">
                  <c:v>48.0</c:v>
                </c:pt>
                <c:pt idx="25">
                  <c:v>50.0</c:v>
                </c:pt>
              </c:numCache>
            </c:numRef>
          </c:xVal>
          <c:yVal>
            <c:numRef>
              <c:f>'Fract factors'!$F$4:$F$29</c:f>
              <c:numCache>
                <c:formatCode>0.0</c:formatCode>
                <c:ptCount val="26"/>
                <c:pt idx="0">
                  <c:v>30.83574917146342</c:v>
                </c:pt>
                <c:pt idx="1">
                  <c:v>30.3301652892562</c:v>
                </c:pt>
                <c:pt idx="2">
                  <c:v>29.835493099089</c:v>
                </c:pt>
                <c:pt idx="3">
                  <c:v>29.35142084505594</c:v>
                </c:pt>
                <c:pt idx="4">
                  <c:v>28.87764782614202</c:v>
                </c:pt>
                <c:pt idx="5">
                  <c:v>28.41388392912885</c:v>
                </c:pt>
                <c:pt idx="6">
                  <c:v>27.95984918436442</c:v>
                </c:pt>
                <c:pt idx="7">
                  <c:v>27.51527334312665</c:v>
                </c:pt>
                <c:pt idx="8">
                  <c:v>27.07989547538942</c:v>
                </c:pt>
                <c:pt idx="9">
                  <c:v>26.65346358687309</c:v>
                </c:pt>
                <c:pt idx="10">
                  <c:v>26.23573425433024</c:v>
                </c:pt>
                <c:pt idx="11">
                  <c:v>25.82647227808101</c:v>
                </c:pt>
                <c:pt idx="12">
                  <c:v>25.42545035087122</c:v>
                </c:pt>
                <c:pt idx="13">
                  <c:v>25.03244874218409</c:v>
                </c:pt>
                <c:pt idx="14">
                  <c:v>24.64725499718546</c:v>
                </c:pt>
                <c:pt idx="15">
                  <c:v>24.26966364953323</c:v>
                </c:pt>
                <c:pt idx="16">
                  <c:v>23.89947594732597</c:v>
                </c:pt>
                <c:pt idx="17">
                  <c:v>23.5364995915076</c:v>
                </c:pt>
                <c:pt idx="18">
                  <c:v>23.18054848608623</c:v>
                </c:pt>
                <c:pt idx="19">
                  <c:v>22.83144249956059</c:v>
                </c:pt>
                <c:pt idx="20">
                  <c:v>22.48900723698309</c:v>
                </c:pt>
                <c:pt idx="21">
                  <c:v>22.15307382212143</c:v>
                </c:pt>
                <c:pt idx="22">
                  <c:v>21.82347868920976</c:v>
                </c:pt>
                <c:pt idx="23">
                  <c:v>21.50006338381109</c:v>
                </c:pt>
                <c:pt idx="24">
                  <c:v>21.18267437233719</c:v>
                </c:pt>
                <c:pt idx="25">
                  <c:v>20.87116285979929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D4DF-B74A-BCDA-B228818C0785}"/>
            </c:ext>
          </c:extLst>
        </c:ser>
        <c:ser>
          <c:idx val="2"/>
          <c:order val="1"/>
          <c:tx>
            <c:v>Kaolinite</c:v>
          </c:tx>
          <c:marker>
            <c:symbol val="none"/>
          </c:marker>
          <c:xVal>
            <c:numRef>
              <c:f>'Fract factors'!$A$4:$A$29</c:f>
              <c:numCache>
                <c:formatCode>General</c:formatCode>
                <c:ptCount val="26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0</c:v>
                </c:pt>
                <c:pt idx="4">
                  <c:v>8.0</c:v>
                </c:pt>
                <c:pt idx="5">
                  <c:v>10.0</c:v>
                </c:pt>
                <c:pt idx="6">
                  <c:v>12.0</c:v>
                </c:pt>
                <c:pt idx="7">
                  <c:v>14.0</c:v>
                </c:pt>
                <c:pt idx="8">
                  <c:v>16.0</c:v>
                </c:pt>
                <c:pt idx="9">
                  <c:v>18.0</c:v>
                </c:pt>
                <c:pt idx="10">
                  <c:v>20.0</c:v>
                </c:pt>
                <c:pt idx="11">
                  <c:v>22.0</c:v>
                </c:pt>
                <c:pt idx="12">
                  <c:v>24.0</c:v>
                </c:pt>
                <c:pt idx="13">
                  <c:v>26.0</c:v>
                </c:pt>
                <c:pt idx="14">
                  <c:v>28.0</c:v>
                </c:pt>
                <c:pt idx="15">
                  <c:v>30.0</c:v>
                </c:pt>
                <c:pt idx="16">
                  <c:v>32.0</c:v>
                </c:pt>
                <c:pt idx="17">
                  <c:v>34.0</c:v>
                </c:pt>
                <c:pt idx="18">
                  <c:v>36.0</c:v>
                </c:pt>
                <c:pt idx="19">
                  <c:v>38.0</c:v>
                </c:pt>
                <c:pt idx="20">
                  <c:v>40.0</c:v>
                </c:pt>
                <c:pt idx="21">
                  <c:v>42.0</c:v>
                </c:pt>
                <c:pt idx="22">
                  <c:v>44.0</c:v>
                </c:pt>
                <c:pt idx="23">
                  <c:v>46.0</c:v>
                </c:pt>
                <c:pt idx="24">
                  <c:v>48.0</c:v>
                </c:pt>
                <c:pt idx="25">
                  <c:v>50.0</c:v>
                </c:pt>
              </c:numCache>
            </c:numRef>
          </c:xVal>
          <c:yVal>
            <c:numRef>
              <c:f>'Fract factors'!$C$4:$C$29</c:f>
              <c:numCache>
                <c:formatCode>0.0</c:formatCode>
                <c:ptCount val="26"/>
                <c:pt idx="0">
                  <c:v>30.28256450509197</c:v>
                </c:pt>
                <c:pt idx="1">
                  <c:v>29.74586776859504</c:v>
                </c:pt>
                <c:pt idx="2">
                  <c:v>29.22075421287909</c:v>
                </c:pt>
                <c:pt idx="3">
                  <c:v>28.70689289705939</c:v>
                </c:pt>
                <c:pt idx="4">
                  <c:v>28.20396461544307</c:v>
                </c:pt>
                <c:pt idx="5">
                  <c:v>27.71166140169062</c:v>
                </c:pt>
                <c:pt idx="6">
                  <c:v>27.22968605724839</c:v>
                </c:pt>
                <c:pt idx="7">
                  <c:v>26.75775170270369</c:v>
                </c:pt>
                <c:pt idx="8">
                  <c:v>26.295581350798</c:v>
                </c:pt>
                <c:pt idx="9">
                  <c:v>25.84290749991143</c:v>
                </c:pt>
                <c:pt idx="10">
                  <c:v>25.39947174690445</c:v>
                </c:pt>
                <c:pt idx="11">
                  <c:v>24.96502441827061</c:v>
                </c:pt>
                <c:pt idx="12">
                  <c:v>24.53932421861715</c:v>
                </c:pt>
                <c:pt idx="13">
                  <c:v>24.12213789554923</c:v>
                </c:pt>
                <c:pt idx="14">
                  <c:v>23.71323992008918</c:v>
                </c:pt>
                <c:pt idx="15">
                  <c:v>23.31241218181223</c:v>
                </c:pt>
                <c:pt idx="16">
                  <c:v>22.91944369793066</c:v>
                </c:pt>
                <c:pt idx="17">
                  <c:v>22.53413033560038</c:v>
                </c:pt>
                <c:pt idx="18">
                  <c:v>22.15627454676847</c:v>
                </c:pt>
                <c:pt idx="19">
                  <c:v>21.78568511491817</c:v>
                </c:pt>
                <c:pt idx="20">
                  <c:v>21.42217691310515</c:v>
                </c:pt>
                <c:pt idx="21">
                  <c:v>21.06557067271352</c:v>
                </c:pt>
                <c:pt idx="22">
                  <c:v>20.7156927623919</c:v>
                </c:pt>
                <c:pt idx="23">
                  <c:v>20.372374976661</c:v>
                </c:pt>
                <c:pt idx="24">
                  <c:v>20.03545433371182</c:v>
                </c:pt>
                <c:pt idx="25">
                  <c:v>19.70477288194078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2-D4DF-B74A-BCDA-B228818C0785}"/>
            </c:ext>
          </c:extLst>
        </c:ser>
        <c:ser>
          <c:idx val="4"/>
          <c:order val="2"/>
          <c:spPr>
            <a:ln>
              <a:prstDash val="sysDash"/>
            </a:ln>
          </c:spPr>
          <c:marker>
            <c:symbol val="none"/>
          </c:marker>
          <c:xVal>
            <c:numRef>
              <c:f>'Fract factors'!$A$4:$A$44</c:f>
              <c:numCache>
                <c:formatCode>General</c:formatCode>
                <c:ptCount val="41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0</c:v>
                </c:pt>
                <c:pt idx="4">
                  <c:v>8.0</c:v>
                </c:pt>
                <c:pt idx="5">
                  <c:v>10.0</c:v>
                </c:pt>
                <c:pt idx="6">
                  <c:v>12.0</c:v>
                </c:pt>
                <c:pt idx="7">
                  <c:v>14.0</c:v>
                </c:pt>
                <c:pt idx="8">
                  <c:v>16.0</c:v>
                </c:pt>
                <c:pt idx="9">
                  <c:v>18.0</c:v>
                </c:pt>
                <c:pt idx="10">
                  <c:v>20.0</c:v>
                </c:pt>
                <c:pt idx="11">
                  <c:v>22.0</c:v>
                </c:pt>
                <c:pt idx="12">
                  <c:v>24.0</c:v>
                </c:pt>
                <c:pt idx="13">
                  <c:v>26.0</c:v>
                </c:pt>
                <c:pt idx="14">
                  <c:v>28.0</c:v>
                </c:pt>
                <c:pt idx="15">
                  <c:v>30.0</c:v>
                </c:pt>
                <c:pt idx="16">
                  <c:v>32.0</c:v>
                </c:pt>
                <c:pt idx="17">
                  <c:v>34.0</c:v>
                </c:pt>
                <c:pt idx="18">
                  <c:v>36.0</c:v>
                </c:pt>
                <c:pt idx="19">
                  <c:v>38.0</c:v>
                </c:pt>
                <c:pt idx="20">
                  <c:v>40.0</c:v>
                </c:pt>
                <c:pt idx="21">
                  <c:v>42.0</c:v>
                </c:pt>
                <c:pt idx="22">
                  <c:v>44.0</c:v>
                </c:pt>
                <c:pt idx="23">
                  <c:v>46.0</c:v>
                </c:pt>
                <c:pt idx="24">
                  <c:v>48.0</c:v>
                </c:pt>
                <c:pt idx="25">
                  <c:v>50.0</c:v>
                </c:pt>
                <c:pt idx="26">
                  <c:v>52.0</c:v>
                </c:pt>
                <c:pt idx="27">
                  <c:v>54.2</c:v>
                </c:pt>
                <c:pt idx="28">
                  <c:v>56.2</c:v>
                </c:pt>
                <c:pt idx="29">
                  <c:v>58.2</c:v>
                </c:pt>
                <c:pt idx="30">
                  <c:v>59.2</c:v>
                </c:pt>
                <c:pt idx="31">
                  <c:v>65.0</c:v>
                </c:pt>
                <c:pt idx="32">
                  <c:v>73.0</c:v>
                </c:pt>
                <c:pt idx="33">
                  <c:v>85.0</c:v>
                </c:pt>
                <c:pt idx="34">
                  <c:v>92.0</c:v>
                </c:pt>
                <c:pt idx="35">
                  <c:v>110.0</c:v>
                </c:pt>
                <c:pt idx="36">
                  <c:v>227.0</c:v>
                </c:pt>
                <c:pt idx="37">
                  <c:v>350.0</c:v>
                </c:pt>
                <c:pt idx="38">
                  <c:v>400.0</c:v>
                </c:pt>
                <c:pt idx="39">
                  <c:v>500.0</c:v>
                </c:pt>
                <c:pt idx="40">
                  <c:v>1050.0</c:v>
                </c:pt>
              </c:numCache>
            </c:numRef>
          </c:xVal>
          <c:yVal>
            <c:numRef>
              <c:f>'Fract factors'!$O$4:$O$44</c:f>
              <c:numCache>
                <c:formatCode>0.0</c:formatCode>
                <c:ptCount val="41"/>
                <c:pt idx="0">
                  <c:v>29.04487637080868</c:v>
                </c:pt>
                <c:pt idx="1">
                  <c:v>28.59630545454545</c:v>
                </c:pt>
                <c:pt idx="2">
                  <c:v>28.1567785718568</c:v>
                </c:pt>
                <c:pt idx="3">
                  <c:v>27.72604643003044</c:v>
                </c:pt>
                <c:pt idx="4">
                  <c:v>27.30386838261927</c:v>
                </c:pt>
                <c:pt idx="5">
                  <c:v>26.89001206957261</c:v>
                </c:pt>
                <c:pt idx="6">
                  <c:v>26.48425307479224</c:v>
                </c:pt>
                <c:pt idx="7">
                  <c:v>26.08637460015296</c:v>
                </c:pt>
                <c:pt idx="8">
                  <c:v>25.69616715508675</c:v>
                </c:pt>
                <c:pt idx="9">
                  <c:v>25.31342826088497</c:v>
                </c:pt>
                <c:pt idx="10">
                  <c:v>24.93796216892451</c:v>
                </c:pt>
                <c:pt idx="11">
                  <c:v>24.56957959207121</c:v>
                </c:pt>
                <c:pt idx="12">
                  <c:v>24.20809744855967</c:v>
                </c:pt>
                <c:pt idx="13">
                  <c:v>23.85333861768884</c:v>
                </c:pt>
                <c:pt idx="14">
                  <c:v>23.50513170671405</c:v>
                </c:pt>
                <c:pt idx="15">
                  <c:v>23.16331082835016</c:v>
                </c:pt>
                <c:pt idx="16">
                  <c:v>22.82771538833647</c:v>
                </c:pt>
                <c:pt idx="17">
                  <c:v>22.49818988254514</c:v>
                </c:pt>
                <c:pt idx="18">
                  <c:v>22.17458370314513</c:v>
                </c:pt>
                <c:pt idx="19">
                  <c:v>21.8567509533607</c:v>
                </c:pt>
                <c:pt idx="20">
                  <c:v>21.54455027039165</c:v>
                </c:pt>
                <c:pt idx="21">
                  <c:v>21.23784465608466</c:v>
                </c:pt>
                <c:pt idx="22">
                  <c:v>20.93650131496979</c:v>
                </c:pt>
                <c:pt idx="23">
                  <c:v>20.64039149929738</c:v>
                </c:pt>
                <c:pt idx="24">
                  <c:v>20.34939036073019</c:v>
                </c:pt>
                <c:pt idx="25">
                  <c:v>20.0633768083658</c:v>
                </c:pt>
                <c:pt idx="26">
                  <c:v>19.78223337278102</c:v>
                </c:pt>
                <c:pt idx="27">
                  <c:v>19.47846464667236</c:v>
                </c:pt>
                <c:pt idx="28">
                  <c:v>19.2071814716925</c:v>
                </c:pt>
                <c:pt idx="29">
                  <c:v>18.9404258965203</c:v>
                </c:pt>
                <c:pt idx="30">
                  <c:v>18.80871336328949</c:v>
                </c:pt>
                <c:pt idx="31">
                  <c:v>18.06594822870348</c:v>
                </c:pt>
                <c:pt idx="32">
                  <c:v>17.09748387984898</c:v>
                </c:pt>
                <c:pt idx="33">
                  <c:v>15.75553422677195</c:v>
                </c:pt>
                <c:pt idx="34">
                  <c:v>15.02837287295928</c:v>
                </c:pt>
                <c:pt idx="35">
                  <c:v>13.32396698211863</c:v>
                </c:pt>
                <c:pt idx="36">
                  <c:v>6.07176</c:v>
                </c:pt>
                <c:pt idx="37">
                  <c:v>2.118665513373127</c:v>
                </c:pt>
                <c:pt idx="38">
                  <c:v>1.038095540448945</c:v>
                </c:pt>
                <c:pt idx="39">
                  <c:v>-0.593032185818596</c:v>
                </c:pt>
                <c:pt idx="40">
                  <c:v>-4.431070387887078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4-D4DF-B74A-BCDA-B228818C0785}"/>
            </c:ext>
          </c:extLst>
        </c:ser>
        <c:ser>
          <c:idx val="5"/>
          <c:order val="3"/>
          <c:spPr>
            <a:ln w="19050">
              <a:solidFill>
                <a:schemeClr val="bg1">
                  <a:lumMod val="65000"/>
                </a:schemeClr>
              </a:solidFill>
            </a:ln>
          </c:spPr>
          <c:marker>
            <c:symbol val="none"/>
          </c:marker>
          <c:xVal>
            <c:numRef>
              <c:f>'Fract factors'!$Q$4:$Q$44</c:f>
              <c:numCache>
                <c:formatCode>0.0</c:formatCode>
                <c:ptCount val="41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0</c:v>
                </c:pt>
                <c:pt idx="4">
                  <c:v>8.0</c:v>
                </c:pt>
                <c:pt idx="5">
                  <c:v>10.0</c:v>
                </c:pt>
                <c:pt idx="6">
                  <c:v>12.0</c:v>
                </c:pt>
                <c:pt idx="7">
                  <c:v>14.0</c:v>
                </c:pt>
                <c:pt idx="8">
                  <c:v>16.0</c:v>
                </c:pt>
                <c:pt idx="9">
                  <c:v>18.0</c:v>
                </c:pt>
                <c:pt idx="10">
                  <c:v>20.0</c:v>
                </c:pt>
                <c:pt idx="11">
                  <c:v>22.0</c:v>
                </c:pt>
                <c:pt idx="12">
                  <c:v>24.0</c:v>
                </c:pt>
                <c:pt idx="13">
                  <c:v>26.0</c:v>
                </c:pt>
                <c:pt idx="14">
                  <c:v>28.0</c:v>
                </c:pt>
                <c:pt idx="15">
                  <c:v>30.0</c:v>
                </c:pt>
                <c:pt idx="16">
                  <c:v>32.0</c:v>
                </c:pt>
                <c:pt idx="17">
                  <c:v>34.0</c:v>
                </c:pt>
                <c:pt idx="18">
                  <c:v>36.0</c:v>
                </c:pt>
                <c:pt idx="19">
                  <c:v>38.0</c:v>
                </c:pt>
                <c:pt idx="20">
                  <c:v>40.0</c:v>
                </c:pt>
                <c:pt idx="21">
                  <c:v>42.0</c:v>
                </c:pt>
                <c:pt idx="22">
                  <c:v>44.0</c:v>
                </c:pt>
                <c:pt idx="23">
                  <c:v>46.0</c:v>
                </c:pt>
                <c:pt idx="24">
                  <c:v>48.0</c:v>
                </c:pt>
                <c:pt idx="25">
                  <c:v>50.0</c:v>
                </c:pt>
                <c:pt idx="26">
                  <c:v>52.0</c:v>
                </c:pt>
                <c:pt idx="27">
                  <c:v>54.2</c:v>
                </c:pt>
                <c:pt idx="28">
                  <c:v>56.2</c:v>
                </c:pt>
                <c:pt idx="29">
                  <c:v>58.2</c:v>
                </c:pt>
                <c:pt idx="30">
                  <c:v>59.2</c:v>
                </c:pt>
                <c:pt idx="31">
                  <c:v>65.0</c:v>
                </c:pt>
                <c:pt idx="32">
                  <c:v>73.0</c:v>
                </c:pt>
                <c:pt idx="33" formatCode="General">
                  <c:v>85.0</c:v>
                </c:pt>
                <c:pt idx="34" formatCode="General">
                  <c:v>92.0</c:v>
                </c:pt>
                <c:pt idx="35" formatCode="General">
                  <c:v>110.0</c:v>
                </c:pt>
                <c:pt idx="36" formatCode="General">
                  <c:v>227.0</c:v>
                </c:pt>
                <c:pt idx="37" formatCode="General">
                  <c:v>350.0</c:v>
                </c:pt>
                <c:pt idx="38" formatCode="General">
                  <c:v>400.0</c:v>
                </c:pt>
                <c:pt idx="39" formatCode="General">
                  <c:v>500.0</c:v>
                </c:pt>
                <c:pt idx="40" formatCode="General">
                  <c:v>1050.0</c:v>
                </c:pt>
              </c:numCache>
            </c:numRef>
          </c:xVal>
          <c:yVal>
            <c:numRef>
              <c:f>'Fract factors'!$U$4:$U$44</c:f>
              <c:numCache>
                <c:formatCode>0.00</c:formatCode>
                <c:ptCount val="41"/>
                <c:pt idx="0">
                  <c:v>44.6067973540501</c:v>
                </c:pt>
                <c:pt idx="1">
                  <c:v>43.86776859504128</c:v>
                </c:pt>
                <c:pt idx="2">
                  <c:v>43.14535573251313</c:v>
                </c:pt>
                <c:pt idx="3">
                  <c:v>42.43907452370855</c:v>
                </c:pt>
                <c:pt idx="4">
                  <c:v>41.74845809956814</c:v>
                </c:pt>
                <c:pt idx="5">
                  <c:v>41.07305622494975</c:v>
                </c:pt>
                <c:pt idx="6">
                  <c:v>40.41243459526003</c:v>
                </c:pt>
                <c:pt idx="7">
                  <c:v>39.76617416746591</c:v>
                </c:pt>
                <c:pt idx="8">
                  <c:v>39.1338705235809</c:v>
                </c:pt>
                <c:pt idx="9">
                  <c:v>38.515133264841</c:v>
                </c:pt>
                <c:pt idx="10">
                  <c:v>37.9095854348915</c:v>
                </c:pt>
                <c:pt idx="11">
                  <c:v>37.3168629704108</c:v>
                </c:pt>
                <c:pt idx="12">
                  <c:v>36.73661417769159</c:v>
                </c:pt>
                <c:pt idx="13">
                  <c:v>36.16849923378933</c:v>
                </c:pt>
                <c:pt idx="14">
                  <c:v>35.61218971093035</c:v>
                </c:pt>
                <c:pt idx="15">
                  <c:v>35.06736812295091</c:v>
                </c:pt>
                <c:pt idx="16">
                  <c:v>34.53372749260949</c:v>
                </c:pt>
                <c:pt idx="17">
                  <c:v>34.0109709386837</c:v>
                </c:pt>
                <c:pt idx="18">
                  <c:v>33.49881128182571</c:v>
                </c:pt>
                <c:pt idx="19">
                  <c:v>32.99697066821059</c:v>
                </c:pt>
                <c:pt idx="20">
                  <c:v>32.50518021006646</c:v>
                </c:pt>
                <c:pt idx="21">
                  <c:v>32.02317964222726</c:v>
                </c:pt>
                <c:pt idx="22">
                  <c:v>31.55071699389983</c:v>
                </c:pt>
                <c:pt idx="23">
                  <c:v>31.08754827487934</c:v>
                </c:pt>
                <c:pt idx="24">
                  <c:v>30.63343717549325</c:v>
                </c:pt>
                <c:pt idx="25">
                  <c:v>30.18815477959149</c:v>
                </c:pt>
                <c:pt idx="26">
                  <c:v>29.75147928994082</c:v>
                </c:pt>
                <c:pt idx="27">
                  <c:v>29.28082089418404</c:v>
                </c:pt>
                <c:pt idx="28">
                  <c:v>28.86152814954033</c:v>
                </c:pt>
                <c:pt idx="29">
                  <c:v>28.45019720413545</c:v>
                </c:pt>
                <c:pt idx="30">
                  <c:v>28.24745616130365</c:v>
                </c:pt>
                <c:pt idx="31">
                  <c:v>27.10864465529918</c:v>
                </c:pt>
                <c:pt idx="32">
                  <c:v>25.63567108824217</c:v>
                </c:pt>
                <c:pt idx="33">
                  <c:v>23.61817671108892</c:v>
                </c:pt>
                <c:pt idx="34">
                  <c:v>22.53706136235692</c:v>
                </c:pt>
                <c:pt idx="35">
                  <c:v>20.03899406226779</c:v>
                </c:pt>
                <c:pt idx="36">
                  <c:v>10.12</c:v>
                </c:pt>
                <c:pt idx="37">
                  <c:v>5.409284026702462</c:v>
                </c:pt>
                <c:pt idx="38">
                  <c:v>4.249010330537452</c:v>
                </c:pt>
                <c:pt idx="39">
                  <c:v>2.635018551400853</c:v>
                </c:pt>
                <c:pt idx="40">
                  <c:v>-0.200248067648996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5-D4DF-B74A-BCDA-B228818C0785}"/>
            </c:ext>
          </c:extLst>
        </c:ser>
        <c:ser>
          <c:idx val="6"/>
          <c:order val="4"/>
          <c:spPr>
            <a:ln w="22225">
              <a:solidFill>
                <a:schemeClr val="tx2">
                  <a:lumMod val="20000"/>
                  <a:lumOff val="80000"/>
                </a:schemeClr>
              </a:solidFill>
              <a:prstDash val="sysDash"/>
            </a:ln>
          </c:spPr>
          <c:marker>
            <c:symbol val="none"/>
          </c:marker>
          <c:xVal>
            <c:numRef>
              <c:f>'Fract factors'!$Q$4:$Q$43</c:f>
              <c:numCache>
                <c:formatCode>0.0</c:formatCode>
                <c:ptCount val="40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0</c:v>
                </c:pt>
                <c:pt idx="4">
                  <c:v>8.0</c:v>
                </c:pt>
                <c:pt idx="5">
                  <c:v>10.0</c:v>
                </c:pt>
                <c:pt idx="6">
                  <c:v>12.0</c:v>
                </c:pt>
                <c:pt idx="7">
                  <c:v>14.0</c:v>
                </c:pt>
                <c:pt idx="8">
                  <c:v>16.0</c:v>
                </c:pt>
                <c:pt idx="9">
                  <c:v>18.0</c:v>
                </c:pt>
                <c:pt idx="10">
                  <c:v>20.0</c:v>
                </c:pt>
                <c:pt idx="11">
                  <c:v>22.0</c:v>
                </c:pt>
                <c:pt idx="12">
                  <c:v>24.0</c:v>
                </c:pt>
                <c:pt idx="13">
                  <c:v>26.0</c:v>
                </c:pt>
                <c:pt idx="14">
                  <c:v>28.0</c:v>
                </c:pt>
                <c:pt idx="15">
                  <c:v>30.0</c:v>
                </c:pt>
                <c:pt idx="16">
                  <c:v>32.0</c:v>
                </c:pt>
                <c:pt idx="17">
                  <c:v>34.0</c:v>
                </c:pt>
                <c:pt idx="18">
                  <c:v>36.0</c:v>
                </c:pt>
                <c:pt idx="19">
                  <c:v>38.0</c:v>
                </c:pt>
                <c:pt idx="20">
                  <c:v>40.0</c:v>
                </c:pt>
                <c:pt idx="21">
                  <c:v>42.0</c:v>
                </c:pt>
                <c:pt idx="22">
                  <c:v>44.0</c:v>
                </c:pt>
                <c:pt idx="23">
                  <c:v>46.0</c:v>
                </c:pt>
                <c:pt idx="24">
                  <c:v>48.0</c:v>
                </c:pt>
                <c:pt idx="25">
                  <c:v>50.0</c:v>
                </c:pt>
                <c:pt idx="26">
                  <c:v>52.0</c:v>
                </c:pt>
                <c:pt idx="27">
                  <c:v>54.2</c:v>
                </c:pt>
                <c:pt idx="28">
                  <c:v>56.2</c:v>
                </c:pt>
                <c:pt idx="29">
                  <c:v>58.2</c:v>
                </c:pt>
                <c:pt idx="30">
                  <c:v>59.2</c:v>
                </c:pt>
                <c:pt idx="31">
                  <c:v>65.0</c:v>
                </c:pt>
                <c:pt idx="32">
                  <c:v>73.0</c:v>
                </c:pt>
                <c:pt idx="33" formatCode="General">
                  <c:v>85.0</c:v>
                </c:pt>
                <c:pt idx="34" formatCode="General">
                  <c:v>92.0</c:v>
                </c:pt>
                <c:pt idx="35" formatCode="General">
                  <c:v>110.0</c:v>
                </c:pt>
                <c:pt idx="36" formatCode="General">
                  <c:v>227.0</c:v>
                </c:pt>
                <c:pt idx="37" formatCode="General">
                  <c:v>350.0</c:v>
                </c:pt>
                <c:pt idx="38" formatCode="General">
                  <c:v>400.0</c:v>
                </c:pt>
                <c:pt idx="39" formatCode="General">
                  <c:v>500.0</c:v>
                </c:pt>
              </c:numCache>
            </c:numRef>
          </c:xVal>
          <c:yVal>
            <c:numRef>
              <c:f>'Fract factors'!$T$4:$T$44</c:f>
              <c:numCache>
                <c:formatCode>0.0</c:formatCode>
                <c:ptCount val="41"/>
                <c:pt idx="0">
                  <c:v>33.39853933770747</c:v>
                </c:pt>
                <c:pt idx="1">
                  <c:v>32.84327851239664</c:v>
                </c:pt>
                <c:pt idx="2">
                  <c:v>32.3002212761798</c:v>
                </c:pt>
                <c:pt idx="3">
                  <c:v>31.76901582328079</c:v>
                </c:pt>
                <c:pt idx="4">
                  <c:v>31.24932288978099</c:v>
                </c:pt>
                <c:pt idx="5">
                  <c:v>30.74081522181573</c:v>
                </c:pt>
                <c:pt idx="6">
                  <c:v>30.24317706986766</c:v>
                </c:pt>
                <c:pt idx="7">
                  <c:v>29.75610370770557</c:v>
                </c:pt>
                <c:pt idx="8">
                  <c:v>29.27930097460519</c:v>
                </c:pt>
                <c:pt idx="9">
                  <c:v>28.8124848395744</c:v>
                </c:pt>
                <c:pt idx="10">
                  <c:v>28.35538098638306</c:v>
                </c:pt>
                <c:pt idx="11">
                  <c:v>27.90772441827061</c:v>
                </c:pt>
                <c:pt idx="12">
                  <c:v>27.46925908127288</c:v>
                </c:pt>
                <c:pt idx="13">
                  <c:v>27.03973750517328</c:v>
                </c:pt>
                <c:pt idx="14">
                  <c:v>26.61892046114282</c:v>
                </c:pt>
                <c:pt idx="15">
                  <c:v>26.20657663518827</c:v>
                </c:pt>
                <c:pt idx="16">
                  <c:v>25.80248231658156</c:v>
                </c:pt>
                <c:pt idx="17">
                  <c:v>25.40642110048913</c:v>
                </c:pt>
                <c:pt idx="18">
                  <c:v>25.01818360406783</c:v>
                </c:pt>
                <c:pt idx="19">
                  <c:v>24.63756719533503</c:v>
                </c:pt>
                <c:pt idx="20">
                  <c:v>24.2643757341608</c:v>
                </c:pt>
                <c:pt idx="21">
                  <c:v>23.89841932476692</c:v>
                </c:pt>
                <c:pt idx="22">
                  <c:v>23.53951407915294</c:v>
                </c:pt>
                <c:pt idx="23">
                  <c:v>23.18748189090122</c:v>
                </c:pt>
                <c:pt idx="24">
                  <c:v>22.84215021884493</c:v>
                </c:pt>
                <c:pt idx="25">
                  <c:v>22.50335188011004</c:v>
                </c:pt>
                <c:pt idx="26">
                  <c:v>22.170924852071</c:v>
                </c:pt>
                <c:pt idx="27">
                  <c:v>21.81242668743013</c:v>
                </c:pt>
                <c:pt idx="28">
                  <c:v>21.4928739184355</c:v>
                </c:pt>
                <c:pt idx="29">
                  <c:v>21.17922098065299</c:v>
                </c:pt>
                <c:pt idx="30">
                  <c:v>21.02456216640492</c:v>
                </c:pt>
                <c:pt idx="31">
                  <c:v>20.15504375547074</c:v>
                </c:pt>
                <c:pt idx="32">
                  <c:v>19.02829423970062</c:v>
                </c:pt>
                <c:pt idx="33">
                  <c:v>17.48084643737708</c:v>
                </c:pt>
                <c:pt idx="34">
                  <c:v>16.64944610621129</c:v>
                </c:pt>
                <c:pt idx="35">
                  <c:v>14.72186033240393</c:v>
                </c:pt>
                <c:pt idx="36">
                  <c:v>6.9375</c:v>
                </c:pt>
                <c:pt idx="37">
                  <c:v>3.103453898832604</c:v>
                </c:pt>
                <c:pt idx="38">
                  <c:v>2.130306114865684</c:v>
                </c:pt>
                <c:pt idx="39">
                  <c:v>0.742126052961446</c:v>
                </c:pt>
                <c:pt idx="40">
                  <c:v>-1.958525283932335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6-D4DF-B74A-BCDA-B228818C078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1996459808"/>
        <c:axId val="1780125984"/>
      </c:scatterChart>
      <c:valAx>
        <c:axId val="-1996459808"/>
        <c:scaling>
          <c:orientation val="minMax"/>
          <c:max val="500.0"/>
        </c:scaling>
        <c:delete val="0"/>
        <c:axPos val="b"/>
        <c:title>
          <c:tx>
            <c:rich>
              <a:bodyPr/>
              <a:lstStyle/>
              <a:p>
                <a:pPr>
                  <a:defRPr sz="1400"/>
                </a:pPr>
                <a:r>
                  <a:rPr lang="en-US" sz="1400" dirty="0"/>
                  <a:t>Temperature, °C</a:t>
                </a:r>
              </a:p>
            </c:rich>
          </c:tx>
          <c:layout>
            <c:manualLayout>
              <c:xMode val="edge"/>
              <c:yMode val="edge"/>
              <c:x val="0.438404614113725"/>
              <c:y val="0.93029217193446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en-US"/>
          </a:p>
        </c:txPr>
        <c:crossAx val="1780125984"/>
        <c:crosses val="autoZero"/>
        <c:crossBetween val="midCat"/>
      </c:valAx>
      <c:valAx>
        <c:axId val="1780125984"/>
        <c:scaling>
          <c:orientation val="minMax"/>
          <c:max val="40.0"/>
          <c:min val="0.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800"/>
                </a:pPr>
                <a:r>
                  <a:rPr lang="en-US" sz="1800" dirty="0"/>
                  <a:t>1000ln</a:t>
                </a:r>
                <a:r>
                  <a:rPr lang="en-US" sz="1800" baseline="0" dirty="0"/>
                  <a:t> </a:t>
                </a:r>
                <a:r>
                  <a:rPr lang="en-US" sz="1800" baseline="0" dirty="0">
                    <a:latin typeface="Symbol" charset="2"/>
                    <a:cs typeface="Symbol" charset="2"/>
                  </a:rPr>
                  <a:t>a</a:t>
                </a:r>
                <a:r>
                  <a:rPr lang="en-US" sz="1800" baseline="0" dirty="0"/>
                  <a:t> (clay-water)</a:t>
                </a:r>
                <a:endParaRPr lang="en-US" sz="1800" dirty="0"/>
              </a:p>
            </c:rich>
          </c:tx>
          <c:layout>
            <c:manualLayout>
              <c:xMode val="edge"/>
              <c:yMode val="edge"/>
              <c:x val="0.0501982436092998"/>
              <c:y val="0.224606606261564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en-US"/>
          </a:p>
        </c:txPr>
        <c:crossAx val="-1996459808"/>
        <c:crosses val="autoZero"/>
        <c:crossBetween val="midCat"/>
      </c:valAx>
      <c:spPr>
        <a:ln>
          <a:noFill/>
        </a:ln>
      </c:spPr>
    </c:plotArea>
    <c:legend>
      <c:legendPos val="r"/>
      <c:layout>
        <c:manualLayout>
          <c:xMode val="edge"/>
          <c:yMode val="edge"/>
          <c:x val="0.664960272233809"/>
          <c:y val="0.014190967449318"/>
          <c:w val="0.241508583328608"/>
          <c:h val="0.454822326947063"/>
        </c:manualLayout>
      </c:layout>
      <c:overlay val="0"/>
      <c:txPr>
        <a:bodyPr/>
        <a:lstStyle/>
        <a:p>
          <a:pPr>
            <a:defRPr sz="1200"/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76463</cdr:x>
      <cdr:y>0.30795</cdr:y>
    </cdr:from>
    <cdr:to>
      <cdr:x>0.86532</cdr:x>
      <cdr:y>0.35999</cdr:y>
    </cdr:to>
    <cdr:sp macro="" textlink="">
      <cdr:nvSpPr>
        <cdr:cNvPr id="2" name="TextBox 2">
          <a:extLst xmlns:a="http://schemas.openxmlformats.org/drawingml/2006/main">
            <a:ext uri="{FF2B5EF4-FFF2-40B4-BE49-F238E27FC236}">
              <a16:creationId xmlns="" xmlns:a16="http://schemas.microsoft.com/office/drawing/2014/main" id="{DD2B5D7A-8A89-4240-97A6-B83EA7E460A4}"/>
            </a:ext>
          </a:extLst>
        </cdr:cNvPr>
        <cdr:cNvSpPr txBox="1"/>
      </cdr:nvSpPr>
      <cdr:spPr>
        <a:xfrm xmlns:a="http://schemas.openxmlformats.org/drawingml/2006/main">
          <a:off x="4908319" y="1548039"/>
          <a:ext cx="646331" cy="261610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/>
        </a:solidFill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dirty="0">
              <a:latin typeface="Arial" panose="020B0604020202020204" pitchFamily="34" charset="0"/>
              <a:cs typeface="Arial" panose="020B0604020202020204" pitchFamily="34" charset="0"/>
            </a:rPr>
            <a:t>Granite</a:t>
          </a:r>
        </a:p>
      </cdr:txBody>
    </cdr:sp>
  </cdr:relSizeAnchor>
  <cdr:relSizeAnchor xmlns:cdr="http://schemas.openxmlformats.org/drawingml/2006/chartDrawing">
    <cdr:from>
      <cdr:x>0.77368</cdr:x>
      <cdr:y>0.39536</cdr:y>
    </cdr:from>
    <cdr:to>
      <cdr:x>0.88436</cdr:x>
      <cdr:y>0.4474</cdr:y>
    </cdr:to>
    <cdr:sp macro="" textlink="">
      <cdr:nvSpPr>
        <cdr:cNvPr id="3" name="TextBox 2">
          <a:extLst xmlns:a="http://schemas.openxmlformats.org/drawingml/2006/main">
            <a:ext uri="{FF2B5EF4-FFF2-40B4-BE49-F238E27FC236}">
              <a16:creationId xmlns="" xmlns:a16="http://schemas.microsoft.com/office/drawing/2014/main" id="{4593E339-D8CE-4246-9291-389ACBEB7756}"/>
            </a:ext>
          </a:extLst>
        </cdr:cNvPr>
        <cdr:cNvSpPr txBox="1"/>
      </cdr:nvSpPr>
      <cdr:spPr>
        <a:xfrm xmlns:a="http://schemas.openxmlformats.org/drawingml/2006/main">
          <a:off x="4966407" y="1987459"/>
          <a:ext cx="710451" cy="261610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/>
        </a:solidFill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dirty="0">
              <a:latin typeface="Arial" panose="020B0604020202020204" pitchFamily="34" charset="0"/>
              <a:cs typeface="Arial" panose="020B0604020202020204" pitchFamily="34" charset="0"/>
            </a:rPr>
            <a:t>Chlorite </a:t>
          </a:r>
        </a:p>
      </cdr:txBody>
    </cdr:sp>
  </cdr:relSizeAnchor>
  <cdr:relSizeAnchor xmlns:cdr="http://schemas.openxmlformats.org/drawingml/2006/chartDrawing">
    <cdr:from>
      <cdr:x>0.77955</cdr:x>
      <cdr:y>0.69765</cdr:y>
    </cdr:from>
    <cdr:to>
      <cdr:x>0.922</cdr:x>
      <cdr:y>0.74864</cdr:y>
    </cdr:to>
    <cdr:sp macro="" textlink="">
      <cdr:nvSpPr>
        <cdr:cNvPr id="4" name="TextBox 3">
          <a:extLst xmlns:a="http://schemas.openxmlformats.org/drawingml/2006/main">
            <a:ext uri="{FF2B5EF4-FFF2-40B4-BE49-F238E27FC236}">
              <a16:creationId xmlns="" xmlns:a16="http://schemas.microsoft.com/office/drawing/2014/main" id="{26BBD96B-A4A6-C148-A27C-2AFA0F7D549A}"/>
            </a:ext>
          </a:extLst>
        </cdr:cNvPr>
        <cdr:cNvSpPr txBox="1"/>
      </cdr:nvSpPr>
      <cdr:spPr>
        <a:xfrm xmlns:a="http://schemas.openxmlformats.org/drawingml/2006/main">
          <a:off x="5004094" y="3507050"/>
          <a:ext cx="914400" cy="25629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100" i="1" dirty="0">
              <a:solidFill>
                <a:srgbClr val="00B050"/>
              </a:solidFill>
            </a:rPr>
            <a:t>CRB Dikes</a:t>
          </a:r>
        </a:p>
      </cdr:txBody>
    </cdr:sp>
  </cdr:relSizeAnchor>
  <cdr:relSizeAnchor xmlns:cdr="http://schemas.openxmlformats.org/drawingml/2006/chartDrawing">
    <cdr:from>
      <cdr:x>0.72432</cdr:x>
      <cdr:y>0.63691</cdr:y>
    </cdr:from>
    <cdr:to>
      <cdr:x>0.86676</cdr:x>
      <cdr:y>0.68789</cdr:y>
    </cdr:to>
    <cdr:sp macro="" textlink="">
      <cdr:nvSpPr>
        <cdr:cNvPr id="5" name="TextBox 1">
          <a:extLst xmlns:a="http://schemas.openxmlformats.org/drawingml/2006/main">
            <a:ext uri="{FF2B5EF4-FFF2-40B4-BE49-F238E27FC236}">
              <a16:creationId xmlns="" xmlns:a16="http://schemas.microsoft.com/office/drawing/2014/main" id="{DFB59726-9C9C-6A48-B525-6A1770BAF6BD}"/>
            </a:ext>
          </a:extLst>
        </cdr:cNvPr>
        <cdr:cNvSpPr txBox="1"/>
      </cdr:nvSpPr>
      <cdr:spPr>
        <a:xfrm xmlns:a="http://schemas.openxmlformats.org/drawingml/2006/main">
          <a:off x="4649526" y="3201705"/>
          <a:ext cx="914400" cy="256293"/>
        </a:xfrm>
        <a:prstGeom xmlns:a="http://schemas.openxmlformats.org/drawingml/2006/main" prst="rect">
          <a:avLst/>
        </a:prstGeom>
        <a:ln xmlns:a="http://schemas.openxmlformats.org/drawingml/2006/main">
          <a:noFill/>
        </a:ln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i="1" dirty="0">
              <a:solidFill>
                <a:srgbClr val="C00000"/>
              </a:solidFill>
            </a:rPr>
            <a:t>Wallowa granite</a:t>
          </a:r>
          <a:endParaRPr lang="en-US" sz="1100" i="1" dirty="0">
            <a:solidFill>
              <a:srgbClr val="C00000"/>
            </a:solidFill>
          </a:endParaRPr>
        </a:p>
      </cdr:txBody>
    </cdr:sp>
  </cdr:relSizeAnchor>
  <cdr:relSizeAnchor xmlns:cdr="http://schemas.openxmlformats.org/drawingml/2006/chartDrawing">
    <cdr:from>
      <cdr:x>0.37814</cdr:x>
      <cdr:y>0.44902</cdr:y>
    </cdr:from>
    <cdr:to>
      <cdr:x>0.52059</cdr:x>
      <cdr:y>0.5</cdr:y>
    </cdr:to>
    <cdr:sp macro="" textlink="">
      <cdr:nvSpPr>
        <cdr:cNvPr id="6" name="TextBox 1">
          <a:extLst xmlns:a="http://schemas.openxmlformats.org/drawingml/2006/main">
            <a:ext uri="{FF2B5EF4-FFF2-40B4-BE49-F238E27FC236}">
              <a16:creationId xmlns="" xmlns:a16="http://schemas.microsoft.com/office/drawing/2014/main" id="{13EB5181-DC3F-2744-9FBE-DED21713115C}"/>
            </a:ext>
          </a:extLst>
        </cdr:cNvPr>
        <cdr:cNvSpPr txBox="1"/>
      </cdr:nvSpPr>
      <cdr:spPr>
        <a:xfrm xmlns:a="http://schemas.openxmlformats.org/drawingml/2006/main">
          <a:off x="2427377" y="2257172"/>
          <a:ext cx="914400" cy="256293"/>
        </a:xfrm>
        <a:prstGeom xmlns:a="http://schemas.openxmlformats.org/drawingml/2006/main" prst="rect">
          <a:avLst/>
        </a:prstGeom>
        <a:ln xmlns:a="http://schemas.openxmlformats.org/drawingml/2006/main">
          <a:noFill/>
        </a:ln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000" i="1" dirty="0">
              <a:solidFill>
                <a:srgbClr val="C00000"/>
              </a:solidFill>
            </a:rPr>
            <a:t>Lowering </a:t>
          </a:r>
          <a:r>
            <a:rPr lang="en-US" sz="1000" i="1" dirty="0">
              <a:solidFill>
                <a:srgbClr val="C00000"/>
              </a:solidFill>
              <a:latin typeface="Symbol" pitchFamily="2" charset="2"/>
            </a:rPr>
            <a:t>d</a:t>
          </a:r>
          <a:r>
            <a:rPr lang="en-US" sz="1000" i="1" baseline="30000" dirty="0">
              <a:solidFill>
                <a:srgbClr val="C00000"/>
              </a:solidFill>
            </a:rPr>
            <a:t>18</a:t>
          </a:r>
          <a:r>
            <a:rPr lang="en-US" sz="1000" i="1" dirty="0">
              <a:solidFill>
                <a:srgbClr val="C00000"/>
              </a:solidFill>
            </a:rPr>
            <a:t>O value due to water-rock interaction with -11‰</a:t>
          </a:r>
        </a:p>
        <a:p xmlns:a="http://schemas.openxmlformats.org/drawingml/2006/main">
          <a:r>
            <a:rPr lang="en-US" sz="1000" i="1" dirty="0">
              <a:solidFill>
                <a:srgbClr val="C00000"/>
              </a:solidFill>
            </a:rPr>
            <a:t>Meteoric water  will start at this temperature for Wallowa granite</a:t>
          </a:r>
        </a:p>
      </cdr:txBody>
    </cdr:sp>
  </cdr:relSizeAnchor>
  <cdr:relSizeAnchor xmlns:cdr="http://schemas.openxmlformats.org/drawingml/2006/chartDrawing">
    <cdr:from>
      <cdr:x>0.30076</cdr:x>
      <cdr:y>0.54668</cdr:y>
    </cdr:from>
    <cdr:to>
      <cdr:x>0.30914</cdr:x>
      <cdr:y>0.84785</cdr:y>
    </cdr:to>
    <cdr:sp macro="" textlink="">
      <cdr:nvSpPr>
        <cdr:cNvPr id="7" name="Down Arrow 6">
          <a:extLst xmlns:a="http://schemas.openxmlformats.org/drawingml/2006/main">
            <a:ext uri="{FF2B5EF4-FFF2-40B4-BE49-F238E27FC236}">
              <a16:creationId xmlns="" xmlns:a16="http://schemas.microsoft.com/office/drawing/2014/main" id="{D9C6D3BB-EAF6-284F-804B-F3683CA7A014}"/>
            </a:ext>
          </a:extLst>
        </cdr:cNvPr>
        <cdr:cNvSpPr/>
      </cdr:nvSpPr>
      <cdr:spPr>
        <a:xfrm xmlns:a="http://schemas.openxmlformats.org/drawingml/2006/main">
          <a:off x="1930629" y="2748140"/>
          <a:ext cx="53789" cy="1513967"/>
        </a:xfrm>
        <a:prstGeom xmlns:a="http://schemas.openxmlformats.org/drawingml/2006/main" prst="downArrow">
          <a:avLst/>
        </a:prstGeom>
        <a:ln xmlns:a="http://schemas.openxmlformats.org/drawingml/2006/main">
          <a:solidFill>
            <a:srgbClr val="00B050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 dirty="0"/>
        </a:p>
      </cdr:txBody>
    </cdr:sp>
  </cdr:relSizeAnchor>
  <cdr:relSizeAnchor xmlns:cdr="http://schemas.openxmlformats.org/drawingml/2006/chartDrawing">
    <cdr:from>
      <cdr:x>0.36174</cdr:x>
      <cdr:y>0.49001</cdr:y>
    </cdr:from>
    <cdr:to>
      <cdr:x>0.36966</cdr:x>
      <cdr:y>0.84785</cdr:y>
    </cdr:to>
    <cdr:sp macro="" textlink="">
      <cdr:nvSpPr>
        <cdr:cNvPr id="8" name="Down Arrow 7">
          <a:extLst xmlns:a="http://schemas.openxmlformats.org/drawingml/2006/main">
            <a:ext uri="{FF2B5EF4-FFF2-40B4-BE49-F238E27FC236}">
              <a16:creationId xmlns="" xmlns:a16="http://schemas.microsoft.com/office/drawing/2014/main" id="{E769D87D-77A5-2246-ADC5-3C040617BEE1}"/>
            </a:ext>
          </a:extLst>
        </cdr:cNvPr>
        <cdr:cNvSpPr/>
      </cdr:nvSpPr>
      <cdr:spPr>
        <a:xfrm xmlns:a="http://schemas.openxmlformats.org/drawingml/2006/main">
          <a:off x="2322089" y="2463258"/>
          <a:ext cx="50800" cy="1798849"/>
        </a:xfrm>
        <a:prstGeom xmlns:a="http://schemas.openxmlformats.org/drawingml/2006/main" prst="downArrow">
          <a:avLst/>
        </a:prstGeom>
        <a:solidFill xmlns:a="http://schemas.openxmlformats.org/drawingml/2006/main">
          <a:srgbClr val="C00000"/>
        </a:solidFill>
        <a:ln xmlns:a="http://schemas.openxmlformats.org/drawingml/2006/main">
          <a:solidFill>
            <a:srgbClr val="C00000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 dirty="0"/>
        </a:p>
      </cdr:txBody>
    </cdr:sp>
  </cdr:relSizeAnchor>
  <cdr:relSizeAnchor xmlns:cdr="http://schemas.openxmlformats.org/drawingml/2006/chartDrawing">
    <cdr:from>
      <cdr:x>0.42332</cdr:x>
      <cdr:y>0.50634</cdr:y>
    </cdr:from>
    <cdr:to>
      <cdr:x>0.56577</cdr:x>
      <cdr:y>0.55733</cdr:y>
    </cdr:to>
    <cdr:sp macro="" textlink="">
      <cdr:nvSpPr>
        <cdr:cNvPr id="9" name="TextBox 1">
          <a:extLst xmlns:a="http://schemas.openxmlformats.org/drawingml/2006/main">
            <a:ext uri="{FF2B5EF4-FFF2-40B4-BE49-F238E27FC236}">
              <a16:creationId xmlns="" xmlns:a16="http://schemas.microsoft.com/office/drawing/2014/main" id="{65B02F32-3CC8-EB42-9DFA-188D536CC48B}"/>
            </a:ext>
          </a:extLst>
        </cdr:cNvPr>
        <cdr:cNvSpPr txBox="1"/>
      </cdr:nvSpPr>
      <cdr:spPr>
        <a:xfrm xmlns:a="http://schemas.openxmlformats.org/drawingml/2006/main">
          <a:off x="2717387" y="2545355"/>
          <a:ext cx="914400" cy="256293"/>
        </a:xfrm>
        <a:prstGeom xmlns:a="http://schemas.openxmlformats.org/drawingml/2006/main" prst="rect">
          <a:avLst/>
        </a:prstGeom>
        <a:ln xmlns:a="http://schemas.openxmlformats.org/drawingml/2006/main">
          <a:noFill/>
        </a:ln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000" i="1" dirty="0">
              <a:solidFill>
                <a:srgbClr val="00B050"/>
              </a:solidFill>
            </a:rPr>
            <a:t>Lowering </a:t>
          </a:r>
          <a:r>
            <a:rPr lang="en-US" sz="1000" i="1" dirty="0">
              <a:solidFill>
                <a:srgbClr val="00B050"/>
              </a:solidFill>
              <a:latin typeface="Symbol" pitchFamily="2" charset="2"/>
            </a:rPr>
            <a:t>d</a:t>
          </a:r>
          <a:r>
            <a:rPr lang="en-US" sz="1000" i="1" baseline="30000" dirty="0">
              <a:solidFill>
                <a:srgbClr val="00B050"/>
              </a:solidFill>
            </a:rPr>
            <a:t>18</a:t>
          </a:r>
          <a:r>
            <a:rPr lang="en-US" sz="1000" i="1" dirty="0">
              <a:solidFill>
                <a:srgbClr val="00B050"/>
              </a:solidFill>
            </a:rPr>
            <a:t>O value due to water-rock interaction with -11‰</a:t>
          </a:r>
        </a:p>
        <a:p xmlns:a="http://schemas.openxmlformats.org/drawingml/2006/main">
          <a:r>
            <a:rPr lang="en-US" sz="1000" i="1" dirty="0">
              <a:solidFill>
                <a:srgbClr val="00B050"/>
              </a:solidFill>
            </a:rPr>
            <a:t>Meteoric water  will start at this temperature for CRB Basalts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F72FE8-D139-2E47-9683-8689B01A3C74}" type="datetimeFigureOut">
              <a:rPr lang="en-US" smtClean="0"/>
              <a:t>4/15/20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9B89C7C-4365-4745-816D-7F6507BD838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397610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9B89C7C-4365-4745-816D-7F6507BD8382}" type="slidenum">
              <a:rPr lang="en-US" smtClean="0"/>
              <a:t>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918364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3633D2AB-CD9B-1A4C-A98C-57A050A1C10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="" xmlns:a16="http://schemas.microsoft.com/office/drawing/2014/main" id="{E10A7641-CDA0-1A42-BD06-A8209EFB753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0FE44EC9-6F22-D64A-AA81-35B3D70F32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99F9C-EC0C-CB45-9EAB-5FA49D604D48}" type="datetimeFigureOut">
              <a:rPr lang="en-US" smtClean="0"/>
              <a:t>4/15/20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7B6F026A-FAB7-4549-8240-3350B8A115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A99D01B8-0EBE-CA4A-8351-BBEDE806F3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845EA-4E95-5C42-BDF4-671BC8ED6A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284010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38F55530-4A96-CD41-8907-41E1FF6816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FBDAB473-C86E-304E-A208-73ADBA539C7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0F34BDC0-4F0B-D548-BEDB-C3599DC4C9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99F9C-EC0C-CB45-9EAB-5FA49D604D48}" type="datetimeFigureOut">
              <a:rPr lang="en-US" smtClean="0"/>
              <a:t>4/15/20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C66CBA6F-9717-4F4B-B4C5-768A2132AB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1D357A8D-3350-214C-9226-9A5D5BF7EF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845EA-4E95-5C42-BDF4-671BC8ED6A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843359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="" xmlns:a16="http://schemas.microsoft.com/office/drawing/2014/main" id="{EAF1D37B-7A7B-174D-8D5A-A401794E43B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C51C9F15-5ED6-244C-BB5D-0BA3AC87B8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E93E0629-AC34-414F-92F3-F01501189B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99F9C-EC0C-CB45-9EAB-5FA49D604D48}" type="datetimeFigureOut">
              <a:rPr lang="en-US" smtClean="0"/>
              <a:t>4/15/20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1836FBE2-DB02-2040-AA41-E5E2A6FFAE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5D67396F-6CE1-1F43-A7E2-833190E281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845EA-4E95-5C42-BDF4-671BC8ED6A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166735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E56E2994-20B1-8944-BB2B-8BDD34884D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2B44CD51-961C-834E-BC0D-2F5B75ABA18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07DE7BF1-6BE6-2849-B4A0-4629076D53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99F9C-EC0C-CB45-9EAB-5FA49D604D48}" type="datetimeFigureOut">
              <a:rPr lang="en-US" smtClean="0"/>
              <a:t>4/15/20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E922B575-D090-664D-A594-3B7A19D689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293DF4A6-73CF-B54B-8A6E-C77A414A0C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845EA-4E95-5C42-BDF4-671BC8ED6A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648879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33CAB6AE-4365-484E-9078-E0EC4F5FF4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59472462-24BD-A34A-96CB-EDC618B216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41F240F5-9DC3-B348-8AE2-E025E532CC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99F9C-EC0C-CB45-9EAB-5FA49D604D48}" type="datetimeFigureOut">
              <a:rPr lang="en-US" smtClean="0"/>
              <a:t>4/15/20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DC7C1FE5-C492-6842-95F4-68EE307ADA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D52A213C-35C0-6E4E-BA4A-63D5B76513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845EA-4E95-5C42-BDF4-671BC8ED6A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831132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DABF2D49-AAF9-1641-8E77-BCB277E384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7D2ABF09-0173-174B-BA67-D6286BF0661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2220D2DF-0379-C64B-BC7D-445E3DB6ED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9E763E81-EA4E-A840-A718-211CD8F060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99F9C-EC0C-CB45-9EAB-5FA49D604D48}" type="datetimeFigureOut">
              <a:rPr lang="en-US" smtClean="0"/>
              <a:t>4/15/20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72360E9D-4CD4-F845-900F-730E5902CB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FAE4BE7F-7A27-AC4C-B9BA-E40E6BCE11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845EA-4E95-5C42-BDF4-671BC8ED6A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80102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08F17B35-A5CF-F74F-9C02-0065B90B6F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D7975BE4-B096-EE4C-800A-79546460CC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71F50FC0-96D3-8841-B980-EE2316B945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="" xmlns:a16="http://schemas.microsoft.com/office/drawing/2014/main" id="{01919E5E-6695-C24D-873E-447F980D061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="" xmlns:a16="http://schemas.microsoft.com/office/drawing/2014/main" id="{E6F7224A-4ACB-4D4B-A6FC-61867C6427D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="" xmlns:a16="http://schemas.microsoft.com/office/drawing/2014/main" id="{358EBB81-7F86-AC49-9275-C21CD260AF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99F9C-EC0C-CB45-9EAB-5FA49D604D48}" type="datetimeFigureOut">
              <a:rPr lang="en-US" smtClean="0"/>
              <a:t>4/15/20</a:t>
            </a:fld>
            <a:endParaRPr lang="en-US" dirty="0"/>
          </a:p>
        </p:txBody>
      </p:sp>
      <p:sp>
        <p:nvSpPr>
          <p:cNvPr id="8" name="Footer Placeholder 7">
            <a:extLst>
              <a:ext uri="{FF2B5EF4-FFF2-40B4-BE49-F238E27FC236}">
                <a16:creationId xmlns="" xmlns:a16="http://schemas.microsoft.com/office/drawing/2014/main" id="{1429F858-B5CE-5044-93E0-F41D617A4F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="" xmlns:a16="http://schemas.microsoft.com/office/drawing/2014/main" id="{03878012-C0F5-1B43-BA18-F9994F4401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845EA-4E95-5C42-BDF4-671BC8ED6A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795291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034FC592-4BE2-904D-A6C7-4C20B2A06E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="" xmlns:a16="http://schemas.microsoft.com/office/drawing/2014/main" id="{70B1CC85-66C1-1D4A-AC37-2BAD4B0D12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99F9C-EC0C-CB45-9EAB-5FA49D604D48}" type="datetimeFigureOut">
              <a:rPr lang="en-US" smtClean="0"/>
              <a:t>4/15/20</a:t>
            </a:fld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="" xmlns:a16="http://schemas.microsoft.com/office/drawing/2014/main" id="{F85B7941-A91E-DF40-BB94-8967A20C5D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="" xmlns:a16="http://schemas.microsoft.com/office/drawing/2014/main" id="{8376E85C-8ACD-2041-8078-CE1A42B419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845EA-4E95-5C42-BDF4-671BC8ED6A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264248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="" xmlns:a16="http://schemas.microsoft.com/office/drawing/2014/main" id="{FC7D7662-5FDF-D548-AFE9-4BA96B4F87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99F9C-EC0C-CB45-9EAB-5FA49D604D48}" type="datetimeFigureOut">
              <a:rPr lang="en-US" smtClean="0"/>
              <a:t>4/15/20</a:t>
            </a:fld>
            <a:endParaRPr lang="en-US" dirty="0"/>
          </a:p>
        </p:txBody>
      </p:sp>
      <p:sp>
        <p:nvSpPr>
          <p:cNvPr id="3" name="Footer Placeholder 2">
            <a:extLst>
              <a:ext uri="{FF2B5EF4-FFF2-40B4-BE49-F238E27FC236}">
                <a16:creationId xmlns="" xmlns:a16="http://schemas.microsoft.com/office/drawing/2014/main" id="{6D875CA1-5BDF-284E-94BF-A91E090B67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="" xmlns:a16="http://schemas.microsoft.com/office/drawing/2014/main" id="{F069A44C-9827-7040-9771-24D8366F99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845EA-4E95-5C42-BDF4-671BC8ED6A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071652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B709ABE1-C3D7-7844-ABC0-4DF2EDD6B3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5BAC183B-8FA7-DF4B-BE50-1277B171EAF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8913C778-9515-CD43-AA4D-641E6E07A0E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D732B901-3C72-B348-B63F-DDB882C499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99F9C-EC0C-CB45-9EAB-5FA49D604D48}" type="datetimeFigureOut">
              <a:rPr lang="en-US" smtClean="0"/>
              <a:t>4/15/20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3BD57613-5431-9E4C-837C-632829EB57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410CD22E-1ABB-2446-BDC9-E5A54F5CFC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845EA-4E95-5C42-BDF4-671BC8ED6A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343182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5FFE15D4-5080-9744-B1E8-5A129DC73A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="" xmlns:a16="http://schemas.microsoft.com/office/drawing/2014/main" id="{41CFBC56-EAE1-DC49-9979-5D1A27A79A4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074AEA9E-66ED-514E-8CB5-AA3C1FBDE0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4C9E0EA8-9616-B948-9C86-640B39AF8E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99F9C-EC0C-CB45-9EAB-5FA49D604D48}" type="datetimeFigureOut">
              <a:rPr lang="en-US" smtClean="0"/>
              <a:t>4/15/20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CF73F49E-64EF-2845-84BF-AFB47CA70A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4FA38914-CD07-4F4F-835C-5896DF1D0B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845EA-4E95-5C42-BDF4-671BC8ED6A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807704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="" xmlns:a16="http://schemas.microsoft.com/office/drawing/2014/main" id="{9F0362FD-3853-AE45-9359-46B98B3327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008CA1FA-18EB-3744-A66B-80A8143986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DDFF2FF3-E744-6140-8A34-5D579134375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C99F9C-EC0C-CB45-9EAB-5FA49D604D48}" type="datetimeFigureOut">
              <a:rPr lang="en-US" smtClean="0"/>
              <a:t>4/15/20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4AC10C12-3070-4F45-9138-D0C0ABEE73A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694B744B-E7C1-0240-A31A-F1B50F33D38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3845EA-4E95-5C42-BDF4-671BC8ED6A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785005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4" Type="http://schemas.openxmlformats.org/officeDocument/2006/relationships/image" Target="../media/image2.jpg"/><Relationship Id="rId5" Type="http://schemas.openxmlformats.org/officeDocument/2006/relationships/image" Target="../media/image3.jp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4" Type="http://schemas.openxmlformats.org/officeDocument/2006/relationships/image" Target="../media/image4.png"/><Relationship Id="rId1" Type="http://schemas.microsoft.com/office/2007/relationships/media" Target="../media/media1.mp4"/><Relationship Id="rId2" Type="http://schemas.openxmlformats.org/officeDocument/2006/relationships/video" Target="../media/media1.mp4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png"/><Relationship Id="rId3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4" Type="http://schemas.openxmlformats.org/officeDocument/2006/relationships/image" Target="../media/image9.tif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B3D10072-0783-5C4C-8F19-302D06E5D4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2378148"/>
            <a:ext cx="11734800" cy="454025"/>
          </a:xfrm>
        </p:spPr>
        <p:txBody>
          <a:bodyPr>
            <a:normAutofit fontScale="90000"/>
          </a:bodyPr>
          <a:lstStyle/>
          <a:p>
            <a:r>
              <a:rPr lang="en-US" dirty="0" smtClean="0"/>
              <a:t>Supplementary Figures</a:t>
            </a:r>
            <a:r>
              <a:rPr lang="en-US" dirty="0"/>
              <a:t/>
            </a:r>
            <a:br>
              <a:rPr lang="en-US" dirty="0"/>
            </a:br>
            <a:r>
              <a:rPr lang="en-US" dirty="0"/>
              <a:t/>
            </a:r>
            <a:br>
              <a:rPr lang="en-US" dirty="0"/>
            </a:br>
            <a:r>
              <a:rPr lang="en-US" sz="1800" dirty="0" smtClean="0"/>
              <a:t> </a:t>
            </a:r>
            <a:endParaRPr lang="en-US" sz="1800" dirty="0"/>
          </a:p>
        </p:txBody>
      </p:sp>
    </p:spTree>
    <p:extLst>
      <p:ext uri="{BB962C8B-B14F-4D97-AF65-F5344CB8AC3E}">
        <p14:creationId xmlns:p14="http://schemas.microsoft.com/office/powerpoint/2010/main" val="27748552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="" xmlns:a16="http://schemas.microsoft.com/office/drawing/2014/main" id="{58C686E6-B126-384E-A42D-FC5ED9E7523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69332"/>
            <a:ext cx="6736580" cy="505243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="" xmlns:a16="http://schemas.microsoft.com/office/drawing/2014/main" id="{6059F0BB-E7AA-224D-98B4-12BBA20E9193}"/>
              </a:ext>
            </a:extLst>
          </p:cNvPr>
          <p:cNvSpPr txBox="1"/>
          <p:nvPr/>
        </p:nvSpPr>
        <p:spPr>
          <a:xfrm>
            <a:off x="0" y="5606433"/>
            <a:ext cx="616867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. </a:t>
            </a:r>
            <a:r>
              <a:rPr lang="en-US" dirty="0" smtClean="0"/>
              <a:t>S1 </a:t>
            </a:r>
            <a:r>
              <a:rPr lang="en-US" dirty="0"/>
              <a:t>Sampled Contact between Maxwell Lake dike basalt and </a:t>
            </a:r>
          </a:p>
          <a:p>
            <a:r>
              <a:rPr lang="en-US" dirty="0"/>
              <a:t>Wallowa tonalitic </a:t>
            </a:r>
            <a:r>
              <a:rPr lang="en-US" dirty="0" smtClean="0"/>
              <a:t>granite, field photos</a:t>
            </a:r>
            <a:endParaRPr lang="en-US" dirty="0"/>
          </a:p>
        </p:txBody>
      </p:sp>
      <p:pic>
        <p:nvPicPr>
          <p:cNvPr id="8" name="Picture 7">
            <a:extLst>
              <a:ext uri="{FF2B5EF4-FFF2-40B4-BE49-F238E27FC236}">
                <a16:creationId xmlns="" xmlns:a16="http://schemas.microsoft.com/office/drawing/2014/main" id="{BB0FD4E8-F897-3F45-A1B4-87DDBA36821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50964" y="3692768"/>
            <a:ext cx="4220309" cy="3165232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="" xmlns:a16="http://schemas.microsoft.com/office/drawing/2014/main" id="{5B8B7D16-4043-E141-85ED-D9F7A10A505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5400000">
            <a:off x="7378503" y="-168355"/>
            <a:ext cx="3165230" cy="4220307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="" xmlns:a16="http://schemas.microsoft.com/office/drawing/2014/main" id="{A558BFF1-D8B1-A847-B850-4D3F582F07A9}"/>
              </a:ext>
            </a:extLst>
          </p:cNvPr>
          <p:cNvSpPr txBox="1"/>
          <p:nvPr/>
        </p:nvSpPr>
        <p:spPr>
          <a:xfrm>
            <a:off x="1367682" y="1913665"/>
            <a:ext cx="954107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i="1" dirty="0">
                <a:solidFill>
                  <a:srgbClr val="FFFF00"/>
                </a:solidFill>
              </a:rPr>
              <a:t>basalt</a:t>
            </a:r>
          </a:p>
          <a:p>
            <a:r>
              <a:rPr lang="en-US" sz="2400" i="1" dirty="0">
                <a:solidFill>
                  <a:srgbClr val="FFFF00"/>
                </a:solidFill>
              </a:rPr>
              <a:t> dik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="" xmlns:a16="http://schemas.microsoft.com/office/drawing/2014/main" id="{F60054B0-6BAC-B74A-BF40-EE32AF5AEB8D}"/>
              </a:ext>
            </a:extLst>
          </p:cNvPr>
          <p:cNvSpPr txBox="1"/>
          <p:nvPr/>
        </p:nvSpPr>
        <p:spPr>
          <a:xfrm>
            <a:off x="5093461" y="1491789"/>
            <a:ext cx="107356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i="1" dirty="0">
                <a:solidFill>
                  <a:srgbClr val="FFFF00"/>
                </a:solidFill>
              </a:rPr>
              <a:t>Partial </a:t>
            </a:r>
          </a:p>
          <a:p>
            <a:r>
              <a:rPr lang="en-US" sz="2400" i="1" dirty="0">
                <a:solidFill>
                  <a:srgbClr val="FFFF00"/>
                </a:solidFill>
              </a:rPr>
              <a:t>melt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="" xmlns:a16="http://schemas.microsoft.com/office/drawing/2014/main" id="{90B92F4D-682C-D143-BE5B-FB796E33B46B}"/>
              </a:ext>
            </a:extLst>
          </p:cNvPr>
          <p:cNvSpPr txBox="1"/>
          <p:nvPr/>
        </p:nvSpPr>
        <p:spPr>
          <a:xfrm rot="16429414">
            <a:off x="3874775" y="1552073"/>
            <a:ext cx="8815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FF00"/>
                </a:solidFill>
              </a:rPr>
              <a:t>contact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="" xmlns:a16="http://schemas.microsoft.com/office/drawing/2014/main" id="{50A06092-D20C-164D-9235-9796AFAF0695}"/>
              </a:ext>
            </a:extLst>
          </p:cNvPr>
          <p:cNvSpPr txBox="1"/>
          <p:nvPr/>
        </p:nvSpPr>
        <p:spPr>
          <a:xfrm>
            <a:off x="6953891" y="3692768"/>
            <a:ext cx="107356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i="1" dirty="0">
                <a:solidFill>
                  <a:srgbClr val="FFFF00"/>
                </a:solidFill>
              </a:rPr>
              <a:t>Partial </a:t>
            </a:r>
          </a:p>
          <a:p>
            <a:r>
              <a:rPr lang="en-US" sz="2400" i="1" dirty="0">
                <a:solidFill>
                  <a:srgbClr val="FFFF00"/>
                </a:solidFill>
              </a:rPr>
              <a:t>melt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="" xmlns:a16="http://schemas.microsoft.com/office/drawing/2014/main" id="{5C0DB96F-A6F9-D14D-980C-1562F15D6D6C}"/>
              </a:ext>
            </a:extLst>
          </p:cNvPr>
          <p:cNvSpPr txBox="1"/>
          <p:nvPr/>
        </p:nvSpPr>
        <p:spPr>
          <a:xfrm>
            <a:off x="9898002" y="660792"/>
            <a:ext cx="117327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i="1" dirty="0"/>
              <a:t>Tonalite</a:t>
            </a:r>
          </a:p>
        </p:txBody>
      </p:sp>
    </p:spTree>
    <p:extLst>
      <p:ext uri="{BB962C8B-B14F-4D97-AF65-F5344CB8AC3E}">
        <p14:creationId xmlns:p14="http://schemas.microsoft.com/office/powerpoint/2010/main" val="30891479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HC_FLOW">
            <a:hlinkClick r:id="" action="ppaction://media"/>
            <a:extLst>
              <a:ext uri="{FF2B5EF4-FFF2-40B4-BE49-F238E27FC236}">
                <a16:creationId xmlns="" xmlns:a16="http://schemas.microsoft.com/office/drawing/2014/main" id="{E203F29F-4F42-ED4C-84BB-5F225BA61CE9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175" y="3175"/>
            <a:ext cx="8359775" cy="68580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="" xmlns:a16="http://schemas.microsoft.com/office/drawing/2014/main" id="{703E458C-E7F1-684A-AB9B-9363FD8372EE}"/>
              </a:ext>
            </a:extLst>
          </p:cNvPr>
          <p:cNvSpPr txBox="1"/>
          <p:nvPr/>
        </p:nvSpPr>
        <p:spPr>
          <a:xfrm>
            <a:off x="7048733" y="1665324"/>
            <a:ext cx="5143267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. </a:t>
            </a:r>
            <a:r>
              <a:rPr lang="en-US" dirty="0" smtClean="0"/>
              <a:t>S2  </a:t>
            </a:r>
            <a:r>
              <a:rPr lang="en-US" dirty="0"/>
              <a:t>Screenshot of movies that simulate </a:t>
            </a:r>
          </a:p>
          <a:p>
            <a:r>
              <a:rPr lang="en-US" dirty="0"/>
              <a:t>hydrothermal flow, oxygen isotope exchange</a:t>
            </a:r>
          </a:p>
          <a:p>
            <a:r>
              <a:rPr lang="en-US" dirty="0"/>
              <a:t>and temperature around Maxwell Lake dikes </a:t>
            </a:r>
          </a:p>
          <a:p>
            <a:r>
              <a:rPr lang="en-US" dirty="0"/>
              <a:t>With magma Flow for 1,5,and 10 years.</a:t>
            </a:r>
          </a:p>
          <a:p>
            <a:r>
              <a:rPr lang="en-US" dirty="0"/>
              <a:t>Magma Flow in movies start at 50 years. Blue </a:t>
            </a:r>
          </a:p>
          <a:p>
            <a:r>
              <a:rPr lang="en-US" dirty="0"/>
              <a:t>stepped  line represent maximum temperature </a:t>
            </a:r>
          </a:p>
          <a:p>
            <a:r>
              <a:rPr lang="en-US" dirty="0"/>
              <a:t>reached during the entire duration of the simulation.</a:t>
            </a:r>
          </a:p>
        </p:txBody>
      </p:sp>
      <p:sp>
        <p:nvSpPr>
          <p:cNvPr id="12" name="Freeform 11">
            <a:extLst>
              <a:ext uri="{FF2B5EF4-FFF2-40B4-BE49-F238E27FC236}">
                <a16:creationId xmlns="" xmlns:a16="http://schemas.microsoft.com/office/drawing/2014/main" id="{3B525DEE-56FF-C241-B204-3043F7913F62}"/>
              </a:ext>
            </a:extLst>
          </p:cNvPr>
          <p:cNvSpPr/>
          <p:nvPr/>
        </p:nvSpPr>
        <p:spPr>
          <a:xfrm>
            <a:off x="4585023" y="314324"/>
            <a:ext cx="3587427" cy="6086475"/>
          </a:xfrm>
          <a:custGeom>
            <a:avLst/>
            <a:gdLst>
              <a:gd name="connsiteX0" fmla="*/ 0 w 3834882"/>
              <a:gd name="connsiteY0" fmla="*/ 0 h 4991878"/>
              <a:gd name="connsiteX1" fmla="*/ 158620 w 3834882"/>
              <a:gd name="connsiteY1" fmla="*/ 681135 h 4991878"/>
              <a:gd name="connsiteX2" fmla="*/ 634482 w 3834882"/>
              <a:gd name="connsiteY2" fmla="*/ 2099388 h 4991878"/>
              <a:gd name="connsiteX3" fmla="*/ 774441 w 3834882"/>
              <a:gd name="connsiteY3" fmla="*/ 2416629 h 4991878"/>
              <a:gd name="connsiteX4" fmla="*/ 1007706 w 3834882"/>
              <a:gd name="connsiteY4" fmla="*/ 2873829 h 4991878"/>
              <a:gd name="connsiteX5" fmla="*/ 1240971 w 3834882"/>
              <a:gd name="connsiteY5" fmla="*/ 3219061 h 4991878"/>
              <a:gd name="connsiteX6" fmla="*/ 1530220 w 3834882"/>
              <a:gd name="connsiteY6" fmla="*/ 3508310 h 4991878"/>
              <a:gd name="connsiteX7" fmla="*/ 2006082 w 3834882"/>
              <a:gd name="connsiteY7" fmla="*/ 3853543 h 4991878"/>
              <a:gd name="connsiteX8" fmla="*/ 2640563 w 3834882"/>
              <a:gd name="connsiteY8" fmla="*/ 4096139 h 4991878"/>
              <a:gd name="connsiteX9" fmla="*/ 3237722 w 3834882"/>
              <a:gd name="connsiteY9" fmla="*/ 4264090 h 4991878"/>
              <a:gd name="connsiteX10" fmla="*/ 3685592 w 3834882"/>
              <a:gd name="connsiteY10" fmla="*/ 4348065 h 4991878"/>
              <a:gd name="connsiteX11" fmla="*/ 3816220 w 3834882"/>
              <a:gd name="connsiteY11" fmla="*/ 4366727 h 4991878"/>
              <a:gd name="connsiteX12" fmla="*/ 3834882 w 3834882"/>
              <a:gd name="connsiteY12" fmla="*/ 4991878 h 4991878"/>
              <a:gd name="connsiteX13" fmla="*/ 3209731 w 3834882"/>
              <a:gd name="connsiteY13" fmla="*/ 4945225 h 4991878"/>
              <a:gd name="connsiteX14" fmla="*/ 2491273 w 3834882"/>
              <a:gd name="connsiteY14" fmla="*/ 4889241 h 4991878"/>
              <a:gd name="connsiteX15" fmla="*/ 1838131 w 3834882"/>
              <a:gd name="connsiteY15" fmla="*/ 4814596 h 4991878"/>
              <a:gd name="connsiteX16" fmla="*/ 1418253 w 3834882"/>
              <a:gd name="connsiteY16" fmla="*/ 4721290 h 4991878"/>
              <a:gd name="connsiteX17" fmla="*/ 1063690 w 3834882"/>
              <a:gd name="connsiteY17" fmla="*/ 4609323 h 4991878"/>
              <a:gd name="connsiteX18" fmla="*/ 821094 w 3834882"/>
              <a:gd name="connsiteY18" fmla="*/ 4488025 h 4991878"/>
              <a:gd name="connsiteX19" fmla="*/ 597159 w 3834882"/>
              <a:gd name="connsiteY19" fmla="*/ 4292082 h 4991878"/>
              <a:gd name="connsiteX20" fmla="*/ 447869 w 3834882"/>
              <a:gd name="connsiteY20" fmla="*/ 4058816 h 4991878"/>
              <a:gd name="connsiteX21" fmla="*/ 335902 w 3834882"/>
              <a:gd name="connsiteY21" fmla="*/ 3713584 h 4991878"/>
              <a:gd name="connsiteX22" fmla="*/ 251926 w 3834882"/>
              <a:gd name="connsiteY22" fmla="*/ 3312367 h 4991878"/>
              <a:gd name="connsiteX23" fmla="*/ 177282 w 3834882"/>
              <a:gd name="connsiteY23" fmla="*/ 2752531 h 4991878"/>
              <a:gd name="connsiteX24" fmla="*/ 102637 w 3834882"/>
              <a:gd name="connsiteY24" fmla="*/ 1978090 h 4991878"/>
              <a:gd name="connsiteX25" fmla="*/ 0 w 3834882"/>
              <a:gd name="connsiteY25" fmla="*/ 0 h 499187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</a:cxnLst>
            <a:rect l="l" t="t" r="r" b="b"/>
            <a:pathLst>
              <a:path w="3834882" h="4991878">
                <a:moveTo>
                  <a:pt x="0" y="0"/>
                </a:moveTo>
                <a:lnTo>
                  <a:pt x="158620" y="681135"/>
                </a:lnTo>
                <a:lnTo>
                  <a:pt x="634482" y="2099388"/>
                </a:lnTo>
                <a:lnTo>
                  <a:pt x="774441" y="2416629"/>
                </a:lnTo>
                <a:lnTo>
                  <a:pt x="1007706" y="2873829"/>
                </a:lnTo>
                <a:lnTo>
                  <a:pt x="1240971" y="3219061"/>
                </a:lnTo>
                <a:lnTo>
                  <a:pt x="1530220" y="3508310"/>
                </a:lnTo>
                <a:lnTo>
                  <a:pt x="2006082" y="3853543"/>
                </a:lnTo>
                <a:lnTo>
                  <a:pt x="2640563" y="4096139"/>
                </a:lnTo>
                <a:lnTo>
                  <a:pt x="3237722" y="4264090"/>
                </a:lnTo>
                <a:lnTo>
                  <a:pt x="3685592" y="4348065"/>
                </a:lnTo>
                <a:lnTo>
                  <a:pt x="3816220" y="4366727"/>
                </a:lnTo>
                <a:lnTo>
                  <a:pt x="3834882" y="4991878"/>
                </a:lnTo>
                <a:lnTo>
                  <a:pt x="3209731" y="4945225"/>
                </a:lnTo>
                <a:lnTo>
                  <a:pt x="2491273" y="4889241"/>
                </a:lnTo>
                <a:lnTo>
                  <a:pt x="1838131" y="4814596"/>
                </a:lnTo>
                <a:lnTo>
                  <a:pt x="1418253" y="4721290"/>
                </a:lnTo>
                <a:lnTo>
                  <a:pt x="1063690" y="4609323"/>
                </a:lnTo>
                <a:lnTo>
                  <a:pt x="821094" y="4488025"/>
                </a:lnTo>
                <a:lnTo>
                  <a:pt x="597159" y="4292082"/>
                </a:lnTo>
                <a:lnTo>
                  <a:pt x="447869" y="4058816"/>
                </a:lnTo>
                <a:lnTo>
                  <a:pt x="335902" y="3713584"/>
                </a:lnTo>
                <a:lnTo>
                  <a:pt x="251926" y="3312367"/>
                </a:lnTo>
                <a:lnTo>
                  <a:pt x="177282" y="2752531"/>
                </a:lnTo>
                <a:lnTo>
                  <a:pt x="102637" y="1978090"/>
                </a:lnTo>
                <a:lnTo>
                  <a:pt x="0" y="0"/>
                </a:lnTo>
                <a:close/>
              </a:path>
            </a:pathLst>
          </a:custGeom>
          <a:solidFill>
            <a:schemeClr val="accent1">
              <a:alpha val="39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3" name="TextBox 12">
            <a:extLst>
              <a:ext uri="{FF2B5EF4-FFF2-40B4-BE49-F238E27FC236}">
                <a16:creationId xmlns="" xmlns:a16="http://schemas.microsoft.com/office/drawing/2014/main" id="{72A30079-2D0A-EC4E-BBE6-58ED3E8C4B96}"/>
              </a:ext>
            </a:extLst>
          </p:cNvPr>
          <p:cNvSpPr txBox="1"/>
          <p:nvPr/>
        </p:nvSpPr>
        <p:spPr>
          <a:xfrm>
            <a:off x="5595815" y="5411214"/>
            <a:ext cx="1781257" cy="461665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200" i="1" dirty="0"/>
              <a:t>Karlstrom et al. (2019)</a:t>
            </a:r>
          </a:p>
          <a:p>
            <a:r>
              <a:rPr lang="en-US" sz="1200" i="1" dirty="0"/>
              <a:t>U-He thermochron profile</a:t>
            </a:r>
          </a:p>
        </p:txBody>
      </p:sp>
    </p:spTree>
    <p:extLst>
      <p:ext uri="{BB962C8B-B14F-4D97-AF65-F5344CB8AC3E}">
        <p14:creationId xmlns:p14="http://schemas.microsoft.com/office/powerpoint/2010/main" val="192121147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6900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="" xmlns:a16="http://schemas.microsoft.com/office/drawing/2014/main" id="{B15A1407-FE8A-4F45-A584-9A002289A57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36659" y="1225177"/>
            <a:ext cx="3853697" cy="408463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="" xmlns:a16="http://schemas.microsoft.com/office/drawing/2014/main" id="{8D29E47F-3983-BB42-8319-EC8CF118035F}"/>
              </a:ext>
            </a:extLst>
          </p:cNvPr>
          <p:cNvSpPr txBox="1"/>
          <p:nvPr/>
        </p:nvSpPr>
        <p:spPr>
          <a:xfrm>
            <a:off x="739802" y="5658829"/>
            <a:ext cx="113952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</a:t>
            </a:r>
            <a:r>
              <a:rPr lang="en-US" dirty="0" smtClean="0"/>
              <a:t>S3</a:t>
            </a:r>
            <a:r>
              <a:rPr lang="en-US" dirty="0"/>
              <a:t>. Exploration of </a:t>
            </a:r>
            <a:r>
              <a:rPr lang="en-US" dirty="0">
                <a:latin typeface="Symbol" pitchFamily="2" charset="2"/>
              </a:rPr>
              <a:t>d</a:t>
            </a:r>
            <a:r>
              <a:rPr lang="en-US" baseline="30000" dirty="0"/>
              <a:t>18</a:t>
            </a:r>
            <a:r>
              <a:rPr lang="en-US" dirty="0"/>
              <a:t>O  depletion around 1m and 10 m thick dikes with different duration of magma flow shown 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="" xmlns:a16="http://schemas.microsoft.com/office/drawing/2014/main" id="{07BE0D66-1B43-6740-9FC7-E9CE2FDD932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49078" y="1225177"/>
            <a:ext cx="3824193" cy="4074842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="" xmlns:a16="http://schemas.microsoft.com/office/drawing/2014/main" id="{50869464-2B84-FE46-A037-BBA1F4278D53}"/>
              </a:ext>
            </a:extLst>
          </p:cNvPr>
          <p:cNvSpPr txBox="1"/>
          <p:nvPr/>
        </p:nvSpPr>
        <p:spPr>
          <a:xfrm rot="16200000">
            <a:off x="5406280" y="3174383"/>
            <a:ext cx="1691425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Symbol" charset="2"/>
                <a:ea typeface="Symbol" charset="2"/>
                <a:cs typeface="Symbol" charset="2"/>
              </a:rPr>
              <a:t>d</a:t>
            </a:r>
            <a:r>
              <a:rPr lang="en-US" sz="1400" baseline="30000" dirty="0"/>
              <a:t>18</a:t>
            </a:r>
            <a:r>
              <a:rPr lang="en-US" sz="1400" dirty="0"/>
              <a:t>O</a:t>
            </a:r>
            <a:r>
              <a:rPr lang="en-US" sz="1400" baseline="-25000" dirty="0"/>
              <a:t>rock</a:t>
            </a:r>
            <a:r>
              <a:rPr lang="en-US" sz="1400" dirty="0"/>
              <a:t>, ‰, VSMOW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="" xmlns:a16="http://schemas.microsoft.com/office/drawing/2014/main" id="{C0E001D1-F78E-AD4A-9C45-B026830B5A68}"/>
              </a:ext>
            </a:extLst>
          </p:cNvPr>
          <p:cNvSpPr txBox="1"/>
          <p:nvPr/>
        </p:nvSpPr>
        <p:spPr>
          <a:xfrm rot="16200000">
            <a:off x="771672" y="3174382"/>
            <a:ext cx="1691425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Symbol" charset="2"/>
                <a:ea typeface="Symbol" charset="2"/>
                <a:cs typeface="Symbol" charset="2"/>
              </a:rPr>
              <a:t>d</a:t>
            </a:r>
            <a:r>
              <a:rPr lang="en-US" sz="1400" baseline="30000" dirty="0"/>
              <a:t>18</a:t>
            </a:r>
            <a:r>
              <a:rPr lang="en-US" sz="1400" dirty="0"/>
              <a:t>O</a:t>
            </a:r>
            <a:r>
              <a:rPr lang="en-US" sz="1400" baseline="-25000" dirty="0"/>
              <a:t>rock</a:t>
            </a:r>
            <a:r>
              <a:rPr lang="en-US" sz="1400" dirty="0"/>
              <a:t>, ‰, VSMOW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="" xmlns:a16="http://schemas.microsoft.com/office/drawing/2014/main" id="{23EFFEC3-E03D-044E-AEE5-EDC2796F4121}"/>
              </a:ext>
            </a:extLst>
          </p:cNvPr>
          <p:cNvSpPr txBox="1"/>
          <p:nvPr/>
        </p:nvSpPr>
        <p:spPr>
          <a:xfrm>
            <a:off x="7404783" y="886623"/>
            <a:ext cx="19174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200 m below surfac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="" xmlns:a16="http://schemas.microsoft.com/office/drawing/2014/main" id="{F5176E8F-AEC6-ED49-8300-2E7117E8361B}"/>
              </a:ext>
            </a:extLst>
          </p:cNvPr>
          <p:cNvSpPr txBox="1"/>
          <p:nvPr/>
        </p:nvSpPr>
        <p:spPr>
          <a:xfrm>
            <a:off x="2850352" y="886623"/>
            <a:ext cx="20216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1000 m below surface</a:t>
            </a:r>
          </a:p>
        </p:txBody>
      </p:sp>
    </p:spTree>
    <p:extLst>
      <p:ext uri="{BB962C8B-B14F-4D97-AF65-F5344CB8AC3E}">
        <p14:creationId xmlns:p14="http://schemas.microsoft.com/office/powerpoint/2010/main" val="168965288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="" xmlns:a16="http://schemas.microsoft.com/office/drawing/2014/main" id="{00000000-0008-0000-0000-000004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80883414"/>
              </p:ext>
            </p:extLst>
          </p:nvPr>
        </p:nvGraphicFramePr>
        <p:xfrm>
          <a:off x="2886406" y="915535"/>
          <a:ext cx="6419188" cy="50269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5">
            <a:extLst>
              <a:ext uri="{FF2B5EF4-FFF2-40B4-BE49-F238E27FC236}">
                <a16:creationId xmlns="" xmlns:a16="http://schemas.microsoft.com/office/drawing/2014/main" id="{B6DF1E1E-7100-7D4C-8002-0E6F086A7AC8}"/>
              </a:ext>
            </a:extLst>
          </p:cNvPr>
          <p:cNvSpPr txBox="1"/>
          <p:nvPr/>
        </p:nvSpPr>
        <p:spPr>
          <a:xfrm>
            <a:off x="3966358" y="4180114"/>
            <a:ext cx="510639" cy="997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2" name="TextBox 1">
            <a:extLst>
              <a:ext uri="{FF2B5EF4-FFF2-40B4-BE49-F238E27FC236}">
                <a16:creationId xmlns="" xmlns:a16="http://schemas.microsoft.com/office/drawing/2014/main" id="{82364D34-1C7A-4B46-B752-8C99880C7F45}"/>
              </a:ext>
            </a:extLst>
          </p:cNvPr>
          <p:cNvSpPr txBox="1"/>
          <p:nvPr/>
        </p:nvSpPr>
        <p:spPr>
          <a:xfrm>
            <a:off x="392270" y="6140210"/>
            <a:ext cx="979736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4 </a:t>
            </a:r>
            <a:r>
              <a:rPr lang="en-US" dirty="0"/>
              <a:t>Mineral  and rock –water oxygen isotopic fractionation factors used in numerical simulations </a:t>
            </a:r>
          </a:p>
          <a:p>
            <a:r>
              <a:rPr lang="en-US" dirty="0"/>
              <a:t>and explanation of isotopic effects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="" xmlns:a16="http://schemas.microsoft.com/office/drawing/2014/main" id="{DD2B5D7A-8A89-4240-97A6-B83EA7E460A4}"/>
              </a:ext>
            </a:extLst>
          </p:cNvPr>
          <p:cNvSpPr txBox="1"/>
          <p:nvPr/>
        </p:nvSpPr>
        <p:spPr>
          <a:xfrm>
            <a:off x="7770298" y="1992373"/>
            <a:ext cx="577402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Basalt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="" xmlns:a16="http://schemas.microsoft.com/office/drawing/2014/main" id="{22799706-E4CB-9041-A993-C82ED89CF812}"/>
              </a:ext>
            </a:extLst>
          </p:cNvPr>
          <p:cNvSpPr txBox="1"/>
          <p:nvPr/>
        </p:nvSpPr>
        <p:spPr>
          <a:xfrm>
            <a:off x="7816184" y="2906939"/>
            <a:ext cx="1268296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Basaltic Andesite</a:t>
            </a:r>
          </a:p>
        </p:txBody>
      </p:sp>
      <p:cxnSp>
        <p:nvCxnSpPr>
          <p:cNvPr id="8" name="Straight Connector 7">
            <a:extLst>
              <a:ext uri="{FF2B5EF4-FFF2-40B4-BE49-F238E27FC236}">
                <a16:creationId xmlns="" xmlns:a16="http://schemas.microsoft.com/office/drawing/2014/main" id="{53D23C98-BD9C-624D-9A98-F900AF6E9F2F}"/>
              </a:ext>
            </a:extLst>
          </p:cNvPr>
          <p:cNvCxnSpPr>
            <a:cxnSpLocks/>
          </p:cNvCxnSpPr>
          <p:nvPr/>
        </p:nvCxnSpPr>
        <p:spPr>
          <a:xfrm>
            <a:off x="3966358" y="4607164"/>
            <a:ext cx="4741360" cy="4851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="" xmlns:a16="http://schemas.microsoft.com/office/drawing/2014/main" id="{0C19EBAB-B5FA-054C-A9D2-42F0990E543E}"/>
              </a:ext>
            </a:extLst>
          </p:cNvPr>
          <p:cNvCxnSpPr>
            <a:cxnSpLocks/>
          </p:cNvCxnSpPr>
          <p:nvPr/>
        </p:nvCxnSpPr>
        <p:spPr>
          <a:xfrm>
            <a:off x="3972334" y="4305846"/>
            <a:ext cx="4741360" cy="48510"/>
          </a:xfrm>
          <a:prstGeom prst="line">
            <a:avLst/>
          </a:prstGeom>
          <a:ln w="3810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="" xmlns:a16="http://schemas.microsoft.com/office/drawing/2014/main" id="{A7F1F911-B8B1-2E48-8855-93ECC26D76B6}"/>
              </a:ext>
            </a:extLst>
          </p:cNvPr>
          <p:cNvCxnSpPr>
            <a:cxnSpLocks/>
          </p:cNvCxnSpPr>
          <p:nvPr/>
        </p:nvCxnSpPr>
        <p:spPr>
          <a:xfrm>
            <a:off x="5217455" y="3356295"/>
            <a:ext cx="3544046" cy="44996"/>
          </a:xfrm>
          <a:prstGeom prst="line">
            <a:avLst/>
          </a:prstGeom>
          <a:ln w="1270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="" xmlns:a16="http://schemas.microsoft.com/office/drawing/2014/main" id="{9DF4A339-EE5D-AE4F-B4FD-103DB0B3A849}"/>
              </a:ext>
            </a:extLst>
          </p:cNvPr>
          <p:cNvCxnSpPr>
            <a:cxnSpLocks/>
          </p:cNvCxnSpPr>
          <p:nvPr/>
        </p:nvCxnSpPr>
        <p:spPr>
          <a:xfrm>
            <a:off x="4832467" y="3638020"/>
            <a:ext cx="3890682" cy="51311"/>
          </a:xfrm>
          <a:prstGeom prst="line">
            <a:avLst/>
          </a:prstGeom>
          <a:ln w="127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Rectangle 16">
            <a:extLst>
              <a:ext uri="{FF2B5EF4-FFF2-40B4-BE49-F238E27FC236}">
                <a16:creationId xmlns="" xmlns:a16="http://schemas.microsoft.com/office/drawing/2014/main" id="{D61232AA-759F-4142-B29E-405C0C2776F5}"/>
              </a:ext>
            </a:extLst>
          </p:cNvPr>
          <p:cNvSpPr/>
          <p:nvPr/>
        </p:nvSpPr>
        <p:spPr>
          <a:xfrm>
            <a:off x="3289852" y="2773018"/>
            <a:ext cx="198783" cy="35645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="" xmlns:a16="http://schemas.microsoft.com/office/drawing/2014/main" id="{94689D40-0D4E-3E4B-B490-BA1A5B29FC3F}"/>
              </a:ext>
            </a:extLst>
          </p:cNvPr>
          <p:cNvSpPr txBox="1"/>
          <p:nvPr/>
        </p:nvSpPr>
        <p:spPr>
          <a:xfrm rot="16200000">
            <a:off x="3113815" y="2781967"/>
            <a:ext cx="5508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rock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="" xmlns:a16="http://schemas.microsoft.com/office/drawing/2014/main" id="{5481EC9E-BCBC-6645-A912-BA29882075E3}"/>
              </a:ext>
            </a:extLst>
          </p:cNvPr>
          <p:cNvSpPr txBox="1"/>
          <p:nvPr/>
        </p:nvSpPr>
        <p:spPr>
          <a:xfrm>
            <a:off x="4450291" y="1855327"/>
            <a:ext cx="175612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Weathering will increase </a:t>
            </a:r>
          </a:p>
          <a:p>
            <a:r>
              <a:rPr lang="en-US" sz="1200" dirty="0">
                <a:latin typeface="Symbol" pitchFamily="2" charset="2"/>
              </a:rPr>
              <a:t>d</a:t>
            </a:r>
            <a:r>
              <a:rPr lang="en-US" sz="1200" baseline="30000" dirty="0">
                <a:latin typeface="Symbol" pitchFamily="2" charset="2"/>
              </a:rPr>
              <a:t>1</a:t>
            </a:r>
            <a:r>
              <a:rPr lang="en-US" sz="1200" baseline="30000" dirty="0"/>
              <a:t>8</a:t>
            </a:r>
            <a:r>
              <a:rPr lang="en-US" sz="1200" dirty="0"/>
              <a:t>O values of rocks</a:t>
            </a: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="" xmlns:a16="http://schemas.microsoft.com/office/drawing/2014/main" id="{19047F99-5AEF-8E4F-BD01-4CBBAF56B776}"/>
              </a:ext>
            </a:extLst>
          </p:cNvPr>
          <p:cNvCxnSpPr>
            <a:stCxn id="19" idx="1"/>
          </p:cNvCxnSpPr>
          <p:nvPr/>
        </p:nvCxnSpPr>
        <p:spPr>
          <a:xfrm flipH="1">
            <a:off x="4221677" y="2086160"/>
            <a:ext cx="228614" cy="45825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6927916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82364D34-1C7A-4B46-B752-8C99880C7F45}"/>
              </a:ext>
            </a:extLst>
          </p:cNvPr>
          <p:cNvSpPr txBox="1"/>
          <p:nvPr/>
        </p:nvSpPr>
        <p:spPr>
          <a:xfrm>
            <a:off x="183365" y="4560792"/>
            <a:ext cx="5262466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</a:t>
            </a:r>
            <a:r>
              <a:rPr lang="en-US" dirty="0"/>
              <a:t>S</a:t>
            </a:r>
            <a:r>
              <a:rPr lang="en-US" dirty="0" smtClean="0"/>
              <a:t>5 </a:t>
            </a:r>
            <a:r>
              <a:rPr lang="en-US" dirty="0" smtClean="0"/>
              <a:t>LA-ICP-MS Concordia Diagram for zircons in</a:t>
            </a:r>
          </a:p>
          <a:p>
            <a:r>
              <a:rPr lang="en-US" dirty="0" smtClean="0"/>
              <a:t> samples CRB-60 and CRB-69 with partial melt around </a:t>
            </a:r>
          </a:p>
          <a:p>
            <a:r>
              <a:rPr lang="en-US" dirty="0" smtClean="0"/>
              <a:t>Maxwell Lake dike </a:t>
            </a:r>
          </a:p>
          <a:p>
            <a:r>
              <a:rPr lang="en-US" dirty="0" smtClean="0"/>
              <a:t> </a:t>
            </a:r>
            <a:endParaRPr lang="en-US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57019"/>
            <a:ext cx="4928260" cy="3833091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28260" y="396086"/>
            <a:ext cx="6976007" cy="2614968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963401" y="3131127"/>
            <a:ext cx="4511517" cy="3495964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8573282" y="3346693"/>
            <a:ext cx="16738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CRB-60: 126±1.2 Ma</a:t>
            </a:r>
            <a:endParaRPr lang="en-US" sz="1400" dirty="0"/>
          </a:p>
        </p:txBody>
      </p:sp>
      <p:sp>
        <p:nvSpPr>
          <p:cNvPr id="10" name="TextBox 9"/>
          <p:cNvSpPr txBox="1"/>
          <p:nvPr/>
        </p:nvSpPr>
        <p:spPr>
          <a:xfrm>
            <a:off x="3008373" y="242197"/>
            <a:ext cx="171014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All data: CRB-69 and </a:t>
            </a:r>
          </a:p>
          <a:p>
            <a:r>
              <a:rPr lang="en-US" sz="1400" dirty="0" smtClean="0"/>
              <a:t>CRB-60: 125±1.2 Ma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9174756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005</TotalTime>
  <Words>250</Words>
  <Application>Microsoft Macintosh PowerPoint</Application>
  <PresentationFormat>Widescreen</PresentationFormat>
  <Paragraphs>50</Paragraphs>
  <Slides>6</Slides>
  <Notes>1</Notes>
  <HiddenSlides>0</HiddenSlides>
  <MMClips>1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Calibri</vt:lpstr>
      <vt:lpstr>Calibri Light</vt:lpstr>
      <vt:lpstr>Symbol</vt:lpstr>
      <vt:lpstr>Arial</vt:lpstr>
      <vt:lpstr>Office Theme</vt:lpstr>
      <vt:lpstr>Supplementary Figures   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2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127</cp:revision>
  <cp:lastPrinted>2020-03-09T04:04:10Z</cp:lastPrinted>
  <dcterms:created xsi:type="dcterms:W3CDTF">2019-09-27T16:20:37Z</dcterms:created>
  <dcterms:modified xsi:type="dcterms:W3CDTF">2020-04-15T20:04:41Z</dcterms:modified>
</cp:coreProperties>
</file>